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5" r:id="rId2"/>
    <p:sldId id="269" r:id="rId3"/>
    <p:sldId id="27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79051" autoAdjust="0"/>
  </p:normalViewPr>
  <p:slideViewPr>
    <p:cSldViewPr snapToGrid="0">
      <p:cViewPr varScale="1">
        <p:scale>
          <a:sx n="64" d="100"/>
          <a:sy n="64" d="100"/>
        </p:scale>
        <p:origin x="108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583CF6-0E94-4424-98A0-ECA233282F07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86C331-E733-438B-BFAC-A174E9B65B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7344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2" name="Google Shape;682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83" name="Google Shape;683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5" name="Google Shape;755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56" name="Google Shape;756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4" name="Google Shape;814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15" name="Google Shape;815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9029CB-7A20-FC21-A860-9FE5B133D3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AFB8CE-D0D8-9CD0-3E9F-590E9F2627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3CE161-85DC-6631-1EF6-C2C1A9C87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9909A4-D758-4D07-47A8-40D02E997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990449-5E07-F90B-17DB-292B627D2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258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651A8-7DB1-61EE-7611-1265A83DC8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DB4E48-53CB-992C-F2E5-C70CC1294D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E9D92-453D-CF25-4765-9AD9BF0D1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8884C6-141C-4A4F-6A0B-0DF8D80B6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3AD75-A310-D5E5-77A9-07C8463C5C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063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3E48CB-A337-0CC3-D954-79465EA251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56A16C-6A93-1E63-7E46-3D5BED3618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1F6C5F-8EFB-2729-DBDC-3AB54330C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6C8A1F-EEFA-FEC6-0A98-948B3317A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E7635-4B19-696C-452F-B8A623FE4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80061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4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1" name="Google Shape;11;p14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609585" lvl="0" indent="-457189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1219170" lvl="1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828754" lvl="2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2438339" lvl="3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3047924" lvl="4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3657509" lvl="5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4267093" lvl="6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4876678" lvl="7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5486263" lvl="8" indent="-423323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2" name="Google Shape;12;p1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333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97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8A243C-DD2E-B716-7C6B-1A5EDD0D0D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A696C9-A05C-B5F1-9287-9B3235BCD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786C6-76F7-1AA1-21AB-770D94232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A403E4-C7CD-42B6-153F-A797061A8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3EC5D7-75D3-2363-3A49-70AA335CA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225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A9E2F-E8A3-41D9-AFB0-D6FFF80DB1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07BC33-A573-FEB1-2C63-45086CE93F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024F8-3A03-62A2-79BE-5B12351CEA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137D45-8E95-2D11-F6E8-1C6615490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353890-7A7C-3C4D-A17C-BCAE79E13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1700FD-1122-2A31-D4E8-D7463F59D1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290E92-9E00-9364-5DA6-02E49C3D23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65715C-8162-C51E-FF29-9A4C20C835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663396-AACD-97B4-784F-79A920506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F2C62A-EC9A-75EB-C549-C6F239BC8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B90AB1-1551-9A56-AEF1-C777B6827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07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50056-5AC3-5027-2FAE-B8E22F296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5FEB3C-56A0-2D74-E5AF-62F20F9042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B2C7B2-A64B-C576-FE8D-C126888BD3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58D66C-5403-6C07-F302-AA0B8B0F9E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E633042-2460-A9CE-A60D-E5D9C936AA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DB5C80-A563-2A63-9E74-792178A889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E63318-791F-DAF2-1DAA-BBCE9EBEC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57D505-4DA7-5E14-F31D-42BF135C0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045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7D9BE-4025-3CC5-5736-CDD6A8131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1CFBBD-62B8-CBAD-5C11-4366038E0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A62FFC-679C-BA59-B085-417CC243F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D99B23-F366-907D-0D9F-DB70223CE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358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8C1766-00E9-A187-7128-365242D3A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1454A31-40CE-8133-3713-E5876928A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6DC9F1-36B1-BB0F-E88D-390E619EE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285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06483-A83A-0D22-1002-66DA32C74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A9EA4-B0C3-B971-4A8C-E69614C58B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112611-A7F2-9311-A7A7-1D06E9B53D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642456-D6F7-5B07-9AD8-9DCAB4B3F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1DFE42-D5E2-9FD4-7B72-57FF65042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CD8649-204C-C015-752D-CCC774427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700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2D4697-81CD-B9AF-BB31-3F3AA05D63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272C0F-D5ED-D48A-18A0-D823431CE0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282E9C-276C-EF18-1BE5-C824C2A015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706D69-BA54-9032-B78C-5C32EC67F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7D3B0D-BF8D-0E32-0F96-88B101817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B72474-99BC-BBAC-1C7A-E363F938E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634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F72855-8D3E-EE36-7384-DE1EFA87C4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ED3978-51D6-8C6B-077E-30A79A426F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B39F0E-C86F-A922-A356-A264119CA9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C056D3-883C-46CF-8ACD-E27DD5847588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8A8B8C-7C08-8494-1A49-CD86C5A0B4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3776E-DC33-6E73-B95C-C1370E8184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9AD745-3F6C-4B87-A754-45EAB3A54A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869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openxmlformats.org/officeDocument/2006/relationships/image" Target="../media/image11.jpg"/><Relationship Id="rId7" Type="http://schemas.openxmlformats.org/officeDocument/2006/relationships/image" Target="../media/image1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4.jpg"/><Relationship Id="rId11" Type="http://schemas.openxmlformats.org/officeDocument/2006/relationships/image" Target="../media/image19.png"/><Relationship Id="rId5" Type="http://schemas.openxmlformats.org/officeDocument/2006/relationships/image" Target="../media/image13.jpg"/><Relationship Id="rId10" Type="http://schemas.openxmlformats.org/officeDocument/2006/relationships/image" Target="../media/image18.jpg"/><Relationship Id="rId4" Type="http://schemas.openxmlformats.org/officeDocument/2006/relationships/image" Target="../media/image12.jpg"/><Relationship Id="rId9" Type="http://schemas.openxmlformats.org/officeDocument/2006/relationships/image" Target="../media/image1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Google Shape;749;p10"/>
          <p:cNvSpPr txBox="1"/>
          <p:nvPr/>
        </p:nvSpPr>
        <p:spPr>
          <a:xfrm>
            <a:off x="7495282" y="470351"/>
            <a:ext cx="3765415" cy="41652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just">
              <a:buClr>
                <a:srgbClr val="000000"/>
              </a:buClr>
              <a:buSzPts val="1400"/>
            </a:pPr>
            <a:r>
              <a:rPr lang="en-US" sz="16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igure </a:t>
            </a:r>
            <a:r>
              <a:rPr lang="en-US" sz="16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1</a:t>
            </a:r>
            <a:r>
              <a:rPr lang="en-US" sz="16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en-US" sz="16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xpression and molecular trafficking of genetic modifiers of exosomes in living human 293T cells</a:t>
            </a:r>
            <a:r>
              <a:rPr lang="en-US" sz="1867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867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ells were transfected with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ither genetic 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odifier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struct 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47-GFP (</a:t>
            </a:r>
            <a:r>
              <a:rPr lang="en-US" sz="1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,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r CD47-Ecto-tVSVG-GFP 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,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r </a:t>
            </a:r>
            <a:r>
              <a:rPr lang="en-US" sz="1400" dirty="0" err="1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Transferrin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US" sz="1400" dirty="0" err="1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VSVG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GFP 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</a:t>
            </a:r>
            <a:r>
              <a:rPr lang="en-US" sz="1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,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r </a:t>
            </a:r>
            <a:r>
              <a:rPr lang="en-US" sz="14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NCAM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US" sz="14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VSVG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GFP (</a:t>
            </a:r>
            <a:r>
              <a:rPr lang="en-US" sz="1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 fusion genes. The confocal images were recorded after 24 hours of </a:t>
            </a:r>
            <a:r>
              <a:rPr lang="en-US" sz="14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ransfection for green fluorescence signals (left column), phase (TLI, middle column) and merge of both (right column). 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ocal localization of genetic modifiers on the plasma membrane and endocytic compartments are indicated by white arrowheads or white arrows respectively. The margin of nucleus (</a:t>
            </a:r>
            <a:r>
              <a:rPr lang="en-US" sz="14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uc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 is marked by dotted lines. Scale bar: 10 </a:t>
            </a:r>
            <a:r>
              <a:rPr lang="en-US" sz="14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μm</a:t>
            </a:r>
            <a:r>
              <a:rPr lang="en-US" sz="14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598682" y="378424"/>
            <a:ext cx="6790946" cy="6060990"/>
            <a:chOff x="598682" y="378424"/>
            <a:chExt cx="6790946" cy="6060990"/>
          </a:xfrm>
        </p:grpSpPr>
        <p:grpSp>
          <p:nvGrpSpPr>
            <p:cNvPr id="686" name="Google Shape;686;p10"/>
            <p:cNvGrpSpPr/>
            <p:nvPr/>
          </p:nvGrpSpPr>
          <p:grpSpPr>
            <a:xfrm>
              <a:off x="867135" y="519826"/>
              <a:ext cx="5755723" cy="5919588"/>
              <a:chOff x="586408" y="591614"/>
              <a:chExt cx="4050392" cy="4261197"/>
            </a:xfrm>
          </p:grpSpPr>
          <p:grpSp>
            <p:nvGrpSpPr>
              <p:cNvPr id="687" name="Google Shape;687;p10"/>
              <p:cNvGrpSpPr/>
              <p:nvPr/>
            </p:nvGrpSpPr>
            <p:grpSpPr>
              <a:xfrm>
                <a:off x="586408" y="591614"/>
                <a:ext cx="4050392" cy="4261197"/>
                <a:chOff x="1995214" y="535598"/>
                <a:chExt cx="3665684" cy="4013893"/>
              </a:xfrm>
            </p:grpSpPr>
            <p:grpSp>
              <p:nvGrpSpPr>
                <p:cNvPr id="688" name="Google Shape;688;p10"/>
                <p:cNvGrpSpPr/>
                <p:nvPr/>
              </p:nvGrpSpPr>
              <p:grpSpPr>
                <a:xfrm>
                  <a:off x="1995214" y="535598"/>
                  <a:ext cx="3665684" cy="4013893"/>
                  <a:chOff x="2017516" y="580203"/>
                  <a:chExt cx="3665684" cy="4013893"/>
                </a:xfrm>
              </p:grpSpPr>
              <p:grpSp>
                <p:nvGrpSpPr>
                  <p:cNvPr id="689" name="Google Shape;689;p10"/>
                  <p:cNvGrpSpPr/>
                  <p:nvPr/>
                </p:nvGrpSpPr>
                <p:grpSpPr>
                  <a:xfrm>
                    <a:off x="2017516" y="580203"/>
                    <a:ext cx="3665684" cy="2276368"/>
                    <a:chOff x="4281161" y="731403"/>
                    <a:chExt cx="5070364" cy="3380198"/>
                  </a:xfrm>
                </p:grpSpPr>
                <p:pic>
                  <p:nvPicPr>
                    <p:cNvPr id="690" name="Google Shape;690;p10"/>
                    <p:cNvPicPr preferRelativeResize="0"/>
                    <p:nvPr/>
                  </p:nvPicPr>
                  <p:blipFill rotWithShape="1">
                    <a:blip r:embed="rId3">
                      <a:alphaModFix/>
                    </a:blip>
                    <a:srcRect l="31430" t="50928" r="33378" b="13880"/>
                    <a:stretch/>
                  </p:blipFill>
                  <p:spPr>
                    <a:xfrm>
                      <a:off x="4375897" y="732318"/>
                      <a:ext cx="1433827" cy="139028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pic>
                  <p:nvPicPr>
                    <p:cNvPr id="691" name="Google Shape;691;p10"/>
                    <p:cNvPicPr preferRelativeResize="0"/>
                    <p:nvPr/>
                  </p:nvPicPr>
                  <p:blipFill rotWithShape="1">
                    <a:blip r:embed="rId4">
                      <a:alphaModFix/>
                    </a:blip>
                    <a:srcRect l="28694" t="50516" r="36116" b="14293"/>
                    <a:stretch/>
                  </p:blipFill>
                  <p:spPr>
                    <a:xfrm>
                      <a:off x="5851061" y="731403"/>
                      <a:ext cx="1433827" cy="139028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pic>
                  <p:nvPicPr>
                    <p:cNvPr id="692" name="Google Shape;692;p10"/>
                    <p:cNvPicPr preferRelativeResize="0"/>
                    <p:nvPr/>
                  </p:nvPicPr>
                  <p:blipFill rotWithShape="1">
                    <a:blip r:embed="rId5">
                      <a:alphaModFix/>
                    </a:blip>
                    <a:srcRect l="30774" t="50651" r="34035" b="14159"/>
                    <a:stretch/>
                  </p:blipFill>
                  <p:spPr>
                    <a:xfrm>
                      <a:off x="7334938" y="740111"/>
                      <a:ext cx="1433827" cy="139028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cxnSp>
                  <p:nvCxnSpPr>
                    <p:cNvPr id="693" name="Google Shape;693;p10"/>
                    <p:cNvCxnSpPr/>
                    <p:nvPr/>
                  </p:nvCxnSpPr>
                  <p:spPr>
                    <a:xfrm>
                      <a:off x="5390023" y="823452"/>
                      <a:ext cx="379562" cy="0"/>
                    </a:xfrm>
                    <a:prstGeom prst="straightConnector1">
                      <a:avLst/>
                    </a:prstGeom>
                    <a:noFill/>
                    <a:ln w="25400" cap="flat" cmpd="sng">
                      <a:solidFill>
                        <a:schemeClr val="lt1"/>
                      </a:solidFill>
                      <a:prstDash val="solid"/>
                      <a:round/>
                      <a:headEnd type="none" w="sm" len="sm"/>
                      <a:tailEnd type="none" w="sm" len="sm"/>
                    </a:ln>
                  </p:spPr>
                </p:cxnSp>
                <p:sp>
                  <p:nvSpPr>
                    <p:cNvPr id="694" name="Google Shape;694;p10"/>
                    <p:cNvSpPr txBox="1"/>
                    <p:nvPr/>
                  </p:nvSpPr>
                  <p:spPr>
                    <a:xfrm>
                      <a:off x="5162767" y="795162"/>
                      <a:ext cx="790546" cy="3304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121900" tIns="60933" rIns="121900" bIns="60933" anchor="t" anchorCtr="0">
                      <a:spAutoFit/>
                    </a:bodyPr>
                    <a:lstStyle/>
                    <a:p>
                      <a:pPr>
                        <a:buClr>
                          <a:srgbClr val="000000"/>
                        </a:buClr>
                        <a:buSzPts val="1000"/>
                      </a:pPr>
                      <a:r>
                        <a:rPr lang="en-US" sz="1333" b="1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 µm</a:t>
                      </a:r>
                      <a:endParaRPr sz="13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p:txBody>
                </p:sp>
                <p:sp>
                  <p:nvSpPr>
                    <p:cNvPr id="695" name="Google Shape;695;p10"/>
                    <p:cNvSpPr txBox="1"/>
                    <p:nvPr/>
                  </p:nvSpPr>
                  <p:spPr>
                    <a:xfrm>
                      <a:off x="4281161" y="3326727"/>
                      <a:ext cx="5070364" cy="78487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spcFirstLastPara="1" wrap="square" lIns="121900" tIns="60933" rIns="121900" bIns="60933" anchor="t" anchorCtr="0">
                      <a:spAutoFit/>
                    </a:bodyPr>
                    <a:lstStyle/>
                    <a:p>
                      <a:pPr>
                        <a:buClr>
                          <a:srgbClr val="000000"/>
                        </a:buClr>
                        <a:buSzPts val="1200"/>
                      </a:pPr>
                      <a:r>
                        <a:rPr lang="en-US" sz="1600" b="1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D47Ecto-tVSVG-eGFP</a:t>
                      </a:r>
                      <a:r>
                        <a:rPr lang="en-US" sz="2133" b="1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                           TLI                      Overlay</a:t>
                      </a:r>
                      <a:endParaRPr sz="21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p:txBody>
                </p:sp>
                <p:pic>
                  <p:nvPicPr>
                    <p:cNvPr id="696" name="Google Shape;696;p10"/>
                    <p:cNvPicPr preferRelativeResize="0"/>
                    <p:nvPr/>
                  </p:nvPicPr>
                  <p:blipFill rotWithShape="1">
                    <a:blip r:embed="rId6">
                      <a:alphaModFix/>
                    </a:blip>
                    <a:srcRect/>
                    <a:stretch/>
                  </p:blipFill>
                  <p:spPr>
                    <a:xfrm>
                      <a:off x="4365188" y="2174813"/>
                      <a:ext cx="1457812" cy="14344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pic>
                  <p:nvPicPr>
                    <p:cNvPr id="697" name="Google Shape;697;p10"/>
                    <p:cNvPicPr preferRelativeResize="0"/>
                    <p:nvPr/>
                  </p:nvPicPr>
                  <p:blipFill rotWithShape="1">
                    <a:blip r:embed="rId7">
                      <a:alphaModFix/>
                    </a:blip>
                    <a:srcRect/>
                    <a:stretch/>
                  </p:blipFill>
                  <p:spPr>
                    <a:xfrm>
                      <a:off x="5851088" y="2179574"/>
                      <a:ext cx="1434487" cy="142282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pic>
                  <p:nvPicPr>
                    <p:cNvPr id="698" name="Google Shape;698;p10"/>
                    <p:cNvPicPr preferRelativeResize="0"/>
                    <p:nvPr/>
                  </p:nvPicPr>
                  <p:blipFill rotWithShape="1">
                    <a:blip r:embed="rId8">
                      <a:alphaModFix/>
                    </a:blip>
                    <a:srcRect/>
                    <a:stretch/>
                  </p:blipFill>
                  <p:spPr>
                    <a:xfrm>
                      <a:off x="7317938" y="2189100"/>
                      <a:ext cx="1457843" cy="141922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</p:pic>
                <p:cxnSp>
                  <p:nvCxnSpPr>
                    <p:cNvPr id="699" name="Google Shape;699;p10"/>
                    <p:cNvCxnSpPr/>
                    <p:nvPr/>
                  </p:nvCxnSpPr>
                  <p:spPr>
                    <a:xfrm>
                      <a:off x="5378518" y="2278437"/>
                      <a:ext cx="347936" cy="0"/>
                    </a:xfrm>
                    <a:prstGeom prst="straightConnector1">
                      <a:avLst/>
                    </a:prstGeom>
                    <a:noFill/>
                    <a:ln w="25400" cap="flat" cmpd="sng">
                      <a:solidFill>
                        <a:schemeClr val="lt1"/>
                      </a:solidFill>
                      <a:prstDash val="solid"/>
                      <a:round/>
                      <a:headEnd type="none" w="sm" len="sm"/>
                      <a:tailEnd type="none" w="sm" len="sm"/>
                    </a:ln>
                  </p:spPr>
                </p:cxnSp>
                <p:cxnSp>
                  <p:nvCxnSpPr>
                    <p:cNvPr id="700" name="Google Shape;700;p10"/>
                    <p:cNvCxnSpPr/>
                    <p:nvPr/>
                  </p:nvCxnSpPr>
                  <p:spPr>
                    <a:xfrm flipH="1">
                      <a:off x="4798575" y="941325"/>
                      <a:ext cx="114300" cy="142875"/>
                    </a:xfrm>
                    <a:prstGeom prst="straightConnector1">
                      <a:avLst/>
                    </a:prstGeom>
                    <a:noFill/>
                    <a:ln w="44450" cap="flat" cmpd="sng">
                      <a:solidFill>
                        <a:srgbClr val="D8D8D8"/>
                      </a:solidFill>
                      <a:prstDash val="dot"/>
                      <a:round/>
                      <a:headEnd type="none" w="sm" len="sm"/>
                      <a:tailEnd type="stealth" w="med" len="med"/>
                    </a:ln>
                  </p:spPr>
                </p:cxnSp>
                <p:cxnSp>
                  <p:nvCxnSpPr>
                    <p:cNvPr id="701" name="Google Shape;701;p10"/>
                    <p:cNvCxnSpPr/>
                    <p:nvPr/>
                  </p:nvCxnSpPr>
                  <p:spPr>
                    <a:xfrm flipH="1">
                      <a:off x="7732275" y="950850"/>
                      <a:ext cx="114300" cy="142875"/>
                    </a:xfrm>
                    <a:prstGeom prst="straightConnector1">
                      <a:avLst/>
                    </a:prstGeom>
                    <a:noFill/>
                    <a:ln w="44450" cap="flat" cmpd="sng">
                      <a:solidFill>
                        <a:srgbClr val="D8D8D8"/>
                      </a:solidFill>
                      <a:prstDash val="dot"/>
                      <a:round/>
                      <a:headEnd type="none" w="sm" len="sm"/>
                      <a:tailEnd type="stealth" w="med" len="med"/>
                    </a:ln>
                  </p:spPr>
                </p:cxnSp>
                <p:cxnSp>
                  <p:nvCxnSpPr>
                    <p:cNvPr id="702" name="Google Shape;702;p10"/>
                    <p:cNvCxnSpPr/>
                    <p:nvPr/>
                  </p:nvCxnSpPr>
                  <p:spPr>
                    <a:xfrm>
                      <a:off x="4817625" y="2855850"/>
                      <a:ext cx="114301" cy="95251"/>
                    </a:xfrm>
                    <a:prstGeom prst="straightConnector1">
                      <a:avLst/>
                    </a:prstGeom>
                    <a:noFill/>
                    <a:ln w="44450" cap="flat" cmpd="sng">
                      <a:solidFill>
                        <a:srgbClr val="D8D8D8"/>
                      </a:solidFill>
                      <a:prstDash val="dot"/>
                      <a:round/>
                      <a:headEnd type="none" w="sm" len="sm"/>
                      <a:tailEnd type="stealth" w="med" len="med"/>
                    </a:ln>
                  </p:spPr>
                </p:cxnSp>
                <p:cxnSp>
                  <p:nvCxnSpPr>
                    <p:cNvPr id="703" name="Google Shape;703;p10"/>
                    <p:cNvCxnSpPr/>
                    <p:nvPr/>
                  </p:nvCxnSpPr>
                  <p:spPr>
                    <a:xfrm>
                      <a:off x="4939679" y="2681678"/>
                      <a:ext cx="151244" cy="143147"/>
                    </a:xfrm>
                    <a:prstGeom prst="straightConnector1">
                      <a:avLst/>
                    </a:prstGeom>
                    <a:noFill/>
                    <a:ln w="19050" cap="flat" cmpd="sng">
                      <a:solidFill>
                        <a:schemeClr val="lt1"/>
                      </a:solidFill>
                      <a:prstDash val="solid"/>
                      <a:round/>
                      <a:headEnd type="none" w="sm" len="sm"/>
                      <a:tailEnd type="triangle" w="med" len="med"/>
                    </a:ln>
                  </p:spPr>
                </p:cxnSp>
                <p:cxnSp>
                  <p:nvCxnSpPr>
                    <p:cNvPr id="704" name="Google Shape;704;p10"/>
                    <p:cNvCxnSpPr/>
                    <p:nvPr/>
                  </p:nvCxnSpPr>
                  <p:spPr>
                    <a:xfrm>
                      <a:off x="7789425" y="2913000"/>
                      <a:ext cx="114301" cy="95251"/>
                    </a:xfrm>
                    <a:prstGeom prst="straightConnector1">
                      <a:avLst/>
                    </a:prstGeom>
                    <a:noFill/>
                    <a:ln w="44450" cap="flat" cmpd="sng">
                      <a:solidFill>
                        <a:srgbClr val="D8D8D8"/>
                      </a:solidFill>
                      <a:prstDash val="dot"/>
                      <a:round/>
                      <a:headEnd type="none" w="sm" len="sm"/>
                      <a:tailEnd type="stealth" w="med" len="med"/>
                    </a:ln>
                  </p:spPr>
                </p:cxnSp>
                <p:cxnSp>
                  <p:nvCxnSpPr>
                    <p:cNvPr id="705" name="Google Shape;705;p10"/>
                    <p:cNvCxnSpPr/>
                    <p:nvPr/>
                  </p:nvCxnSpPr>
                  <p:spPr>
                    <a:xfrm>
                      <a:off x="7941825" y="2808225"/>
                      <a:ext cx="120899" cy="102323"/>
                    </a:xfrm>
                    <a:prstGeom prst="straightConnector1">
                      <a:avLst/>
                    </a:prstGeom>
                    <a:noFill/>
                    <a:ln w="19050" cap="flat" cmpd="sng">
                      <a:solidFill>
                        <a:schemeClr val="lt1"/>
                      </a:solidFill>
                      <a:prstDash val="solid"/>
                      <a:round/>
                      <a:headEnd type="none" w="sm" len="sm"/>
                      <a:tailEnd type="triangle" w="med" len="med"/>
                    </a:ln>
                  </p:spPr>
                </p:cxnSp>
                <p:cxnSp>
                  <p:nvCxnSpPr>
                    <p:cNvPr id="706" name="Google Shape;706;p10"/>
                    <p:cNvCxnSpPr/>
                    <p:nvPr/>
                  </p:nvCxnSpPr>
                  <p:spPr>
                    <a:xfrm flipH="1" flipV="1">
                      <a:off x="5068734" y="1636577"/>
                      <a:ext cx="78315" cy="177271"/>
                    </a:xfrm>
                    <a:prstGeom prst="straightConnector1">
                      <a:avLst/>
                    </a:prstGeom>
                    <a:noFill/>
                    <a:ln w="19050" cap="flat" cmpd="sng">
                      <a:solidFill>
                        <a:schemeClr val="lt1"/>
                      </a:solidFill>
                      <a:prstDash val="solid"/>
                      <a:round/>
                      <a:headEnd type="none" w="sm" len="sm"/>
                      <a:tailEnd type="triangle" w="med" len="med"/>
                    </a:ln>
                  </p:spPr>
                </p:cxnSp>
                <p:cxnSp>
                  <p:nvCxnSpPr>
                    <p:cNvPr id="707" name="Google Shape;707;p10"/>
                    <p:cNvCxnSpPr/>
                    <p:nvPr/>
                  </p:nvCxnSpPr>
                  <p:spPr>
                    <a:xfrm flipH="1" flipV="1">
                      <a:off x="8061157" y="1628352"/>
                      <a:ext cx="92537" cy="131968"/>
                    </a:xfrm>
                    <a:prstGeom prst="straightConnector1">
                      <a:avLst/>
                    </a:prstGeom>
                    <a:noFill/>
                    <a:ln w="19050" cap="flat" cmpd="sng">
                      <a:solidFill>
                        <a:schemeClr val="lt1"/>
                      </a:solidFill>
                      <a:prstDash val="solid"/>
                      <a:round/>
                      <a:headEnd type="none" w="sm" len="sm"/>
                      <a:tailEnd type="triangle" w="med" len="med"/>
                    </a:ln>
                  </p:spPr>
                </p:cxnSp>
              </p:grpSp>
              <p:sp>
                <p:nvSpPr>
                  <p:cNvPr id="708" name="Google Shape;708;p10"/>
                  <p:cNvSpPr txBox="1"/>
                  <p:nvPr/>
                </p:nvSpPr>
                <p:spPr>
                  <a:xfrm>
                    <a:off x="3499274" y="1229799"/>
                    <a:ext cx="512242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TLI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09" name="Google Shape;709;p10"/>
                  <p:cNvSpPr txBox="1"/>
                  <p:nvPr/>
                </p:nvSpPr>
                <p:spPr>
                  <a:xfrm>
                    <a:off x="2490112" y="1283556"/>
                    <a:ext cx="705455" cy="306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000"/>
                    </a:pPr>
                    <a:r>
                      <a:rPr lang="en-US" sz="13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CD47-GFP</a:t>
                    </a:r>
                    <a:endParaRPr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10" name="Google Shape;710;p10"/>
                  <p:cNvSpPr txBox="1"/>
                  <p:nvPr/>
                </p:nvSpPr>
                <p:spPr>
                  <a:xfrm>
                    <a:off x="4472474" y="1223799"/>
                    <a:ext cx="893926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Merge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11" name="Google Shape;711;p10"/>
                  <p:cNvSpPr txBox="1"/>
                  <p:nvPr/>
                </p:nvSpPr>
                <p:spPr>
                  <a:xfrm>
                    <a:off x="3478874" y="2231799"/>
                    <a:ext cx="512242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TLI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12" name="Google Shape;712;p10"/>
                  <p:cNvSpPr txBox="1"/>
                  <p:nvPr/>
                </p:nvSpPr>
                <p:spPr>
                  <a:xfrm>
                    <a:off x="4459274" y="2218599"/>
                    <a:ext cx="683926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Merge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13" name="Google Shape;713;p10"/>
                  <p:cNvSpPr txBox="1"/>
                  <p:nvPr/>
                </p:nvSpPr>
                <p:spPr>
                  <a:xfrm>
                    <a:off x="2250680" y="2158953"/>
                    <a:ext cx="1080271" cy="4450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 algn="ctr">
                      <a:buClr>
                        <a:srgbClr val="000000"/>
                      </a:buClr>
                      <a:buSzPts val="1000"/>
                    </a:pPr>
                    <a:r>
                      <a:rPr lang="en-US" sz="13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CD47-Ecto-tVSVG-GFP</a:t>
                    </a:r>
                    <a:endParaRPr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pic>
                <p:nvPicPr>
                  <p:cNvPr id="714" name="Google Shape;714;p10" descr="A picture containing light, green, dark, lit&#10;&#10;Description automatically generated"/>
                  <p:cNvPicPr preferRelativeResize="0"/>
                  <p:nvPr/>
                </p:nvPicPr>
                <p:blipFill rotWithShape="1">
                  <a:blip r:embed="rId9">
                    <a:alphaModFix/>
                  </a:blip>
                  <a:srcRect/>
                  <a:stretch/>
                </p:blipFill>
                <p:spPr>
                  <a:xfrm>
                    <a:off x="2078260" y="2553413"/>
                    <a:ext cx="1056140" cy="98359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</p:pic>
              <p:pic>
                <p:nvPicPr>
                  <p:cNvPr id="715" name="Google Shape;715;p10" descr="A close-up of a drop of water&#10;&#10;Description automatically generated with low confidence"/>
                  <p:cNvPicPr preferRelativeResize="0"/>
                  <p:nvPr/>
                </p:nvPicPr>
                <p:blipFill rotWithShape="1">
                  <a:blip r:embed="rId10">
                    <a:alphaModFix/>
                  </a:blip>
                  <a:srcRect/>
                  <a:stretch/>
                </p:blipFill>
                <p:spPr>
                  <a:xfrm>
                    <a:off x="3172660" y="2553413"/>
                    <a:ext cx="1020140" cy="98359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</p:pic>
              <p:pic>
                <p:nvPicPr>
                  <p:cNvPr id="716" name="Google Shape;716;p10"/>
                  <p:cNvPicPr preferRelativeResize="0"/>
                  <p:nvPr/>
                </p:nvPicPr>
                <p:blipFill rotWithShape="1">
                  <a:blip r:embed="rId11">
                    <a:alphaModFix/>
                  </a:blip>
                  <a:srcRect/>
                  <a:stretch/>
                </p:blipFill>
                <p:spPr>
                  <a:xfrm>
                    <a:off x="4238260" y="2559321"/>
                    <a:ext cx="1020140" cy="983593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</p:pic>
              <p:sp>
                <p:nvSpPr>
                  <p:cNvPr id="717" name="Google Shape;717;p10"/>
                  <p:cNvSpPr txBox="1"/>
                  <p:nvPr/>
                </p:nvSpPr>
                <p:spPr>
                  <a:xfrm>
                    <a:off x="3451274" y="3262599"/>
                    <a:ext cx="512242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TLI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18" name="Google Shape;718;p10"/>
                  <p:cNvSpPr txBox="1"/>
                  <p:nvPr/>
                </p:nvSpPr>
                <p:spPr>
                  <a:xfrm>
                    <a:off x="4431674" y="3249399"/>
                    <a:ext cx="683926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Merge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19" name="Google Shape;719;p10"/>
                  <p:cNvSpPr txBox="1"/>
                  <p:nvPr/>
                </p:nvSpPr>
                <p:spPr>
                  <a:xfrm>
                    <a:off x="2151404" y="3183394"/>
                    <a:ext cx="1051126" cy="445099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 algn="ctr">
                      <a:buClr>
                        <a:srgbClr val="000000"/>
                      </a:buClr>
                      <a:buSzPts val="1000"/>
                    </a:pPr>
                    <a:r>
                      <a:rPr lang="en-US" sz="1333" b="1" dirty="0" err="1" smtClean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hTransferrin</a:t>
                    </a:r>
                    <a:r>
                      <a:rPr lang="en-US" sz="1333" b="1" dirty="0" smtClean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-</a:t>
                    </a:r>
                    <a:r>
                      <a:rPr lang="en-US" sz="1333" b="1" dirty="0" err="1" smtClean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tVSVG</a:t>
                    </a:r>
                    <a:r>
                      <a:rPr lang="en-US" sz="1333" b="1" dirty="0" smtClean="0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-GFP</a:t>
                    </a:r>
                    <a:endParaRPr sz="1333" b="1" dirty="0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cxnSp>
                <p:nvCxnSpPr>
                  <p:cNvPr id="720" name="Google Shape;720;p10"/>
                  <p:cNvCxnSpPr/>
                  <p:nvPr/>
                </p:nvCxnSpPr>
                <p:spPr>
                  <a:xfrm flipH="1">
                    <a:off x="2445744" y="2707200"/>
                    <a:ext cx="127056" cy="68801"/>
                  </a:xfrm>
                  <a:prstGeom prst="straightConnector1">
                    <a:avLst/>
                  </a:prstGeom>
                  <a:noFill/>
                  <a:ln w="19050" cap="flat" cmpd="sng">
                    <a:solidFill>
                      <a:schemeClr val="lt1"/>
                    </a:solidFill>
                    <a:prstDash val="solid"/>
                    <a:round/>
                    <a:headEnd type="none" w="sm" len="sm"/>
                    <a:tailEnd type="triangle" w="med" len="med"/>
                  </a:ln>
                </p:spPr>
              </p:cxnSp>
              <p:cxnSp>
                <p:nvCxnSpPr>
                  <p:cNvPr id="721" name="Google Shape;721;p10"/>
                  <p:cNvCxnSpPr/>
                  <p:nvPr/>
                </p:nvCxnSpPr>
                <p:spPr>
                  <a:xfrm flipH="1">
                    <a:off x="4599744" y="2694000"/>
                    <a:ext cx="127056" cy="68801"/>
                  </a:xfrm>
                  <a:prstGeom prst="straightConnector1">
                    <a:avLst/>
                  </a:prstGeom>
                  <a:noFill/>
                  <a:ln w="19050" cap="flat" cmpd="sng">
                    <a:solidFill>
                      <a:schemeClr val="lt1"/>
                    </a:solidFill>
                    <a:prstDash val="solid"/>
                    <a:round/>
                    <a:headEnd type="none" w="sm" len="sm"/>
                    <a:tailEnd type="triangle" w="med" len="med"/>
                  </a:ln>
                </p:spPr>
              </p:cxnSp>
              <p:cxnSp>
                <p:nvCxnSpPr>
                  <p:cNvPr id="722" name="Google Shape;722;p10"/>
                  <p:cNvCxnSpPr/>
                  <p:nvPr/>
                </p:nvCxnSpPr>
                <p:spPr>
                  <a:xfrm flipH="1">
                    <a:off x="2929344" y="3054000"/>
                    <a:ext cx="127056" cy="68801"/>
                  </a:xfrm>
                  <a:prstGeom prst="straightConnector1">
                    <a:avLst/>
                  </a:prstGeom>
                  <a:noFill/>
                  <a:ln w="19050" cap="flat" cmpd="sng">
                    <a:solidFill>
                      <a:schemeClr val="lt1"/>
                    </a:solidFill>
                    <a:prstDash val="solid"/>
                    <a:round/>
                    <a:headEnd type="none" w="sm" len="sm"/>
                    <a:tailEnd type="triangle" w="med" len="med"/>
                  </a:ln>
                </p:spPr>
              </p:cxnSp>
              <p:cxnSp>
                <p:nvCxnSpPr>
                  <p:cNvPr id="723" name="Google Shape;723;p10"/>
                  <p:cNvCxnSpPr/>
                  <p:nvPr/>
                </p:nvCxnSpPr>
                <p:spPr>
                  <a:xfrm flipH="1">
                    <a:off x="5083344" y="3040800"/>
                    <a:ext cx="127056" cy="68801"/>
                  </a:xfrm>
                  <a:prstGeom prst="straightConnector1">
                    <a:avLst/>
                  </a:prstGeom>
                  <a:noFill/>
                  <a:ln w="19050" cap="flat" cmpd="sng">
                    <a:solidFill>
                      <a:schemeClr val="lt1"/>
                    </a:solidFill>
                    <a:prstDash val="solid"/>
                    <a:round/>
                    <a:headEnd type="none" w="sm" len="sm"/>
                    <a:tailEnd type="triangle" w="med" len="med"/>
                  </a:ln>
                </p:spPr>
              </p:cxnSp>
              <p:pic>
                <p:nvPicPr>
                  <p:cNvPr id="724" name="Google Shape;724;p10"/>
                  <p:cNvPicPr preferRelativeResize="0"/>
                  <p:nvPr/>
                </p:nvPicPr>
                <p:blipFill rotWithShape="1">
                  <a:blip r:embed="rId12">
                    <a:alphaModFix/>
                  </a:blip>
                  <a:srcRect/>
                  <a:stretch/>
                </p:blipFill>
                <p:spPr>
                  <a:xfrm>
                    <a:off x="2075520" y="3587905"/>
                    <a:ext cx="3187856" cy="94047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</p:pic>
              <p:cxnSp>
                <p:nvCxnSpPr>
                  <p:cNvPr id="725" name="Google Shape;725;p10"/>
                  <p:cNvCxnSpPr/>
                  <p:nvPr/>
                </p:nvCxnSpPr>
                <p:spPr>
                  <a:xfrm>
                    <a:off x="2800597" y="2608525"/>
                    <a:ext cx="274409" cy="0"/>
                  </a:xfrm>
                  <a:prstGeom prst="straightConnector1">
                    <a:avLst/>
                  </a:prstGeom>
                  <a:noFill/>
                  <a:ln w="25400" cap="flat" cmpd="sng">
                    <a:solidFill>
                      <a:schemeClr val="lt1"/>
                    </a:solidFill>
                    <a:prstDash val="solid"/>
                    <a:round/>
                    <a:headEnd type="none" w="sm" len="sm"/>
                    <a:tailEnd type="none" w="sm" len="sm"/>
                  </a:ln>
                </p:spPr>
              </p:cxnSp>
              <p:sp>
                <p:nvSpPr>
                  <p:cNvPr id="726" name="Google Shape;726;p10"/>
                  <p:cNvSpPr txBox="1"/>
                  <p:nvPr/>
                </p:nvSpPr>
                <p:spPr>
                  <a:xfrm>
                    <a:off x="2613996" y="3645122"/>
                    <a:ext cx="571535" cy="22252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60933" rIns="121900" bIns="60933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000"/>
                    </a:pPr>
                    <a:r>
                      <a:rPr lang="en-US" sz="13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10 µm</a:t>
                    </a:r>
                    <a:endParaRPr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27" name="Google Shape;727;p10"/>
                  <p:cNvSpPr txBox="1"/>
                  <p:nvPr/>
                </p:nvSpPr>
                <p:spPr>
                  <a:xfrm>
                    <a:off x="2647450" y="2578321"/>
                    <a:ext cx="571535" cy="22252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60933" rIns="121900" bIns="60933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000"/>
                    </a:pPr>
                    <a:r>
                      <a:rPr lang="en-US" sz="13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10 µm</a:t>
                    </a:r>
                    <a:endParaRPr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28" name="Google Shape;728;p10"/>
                  <p:cNvSpPr txBox="1"/>
                  <p:nvPr/>
                </p:nvSpPr>
                <p:spPr>
                  <a:xfrm>
                    <a:off x="2651167" y="1593297"/>
                    <a:ext cx="571535" cy="22252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60933" rIns="121900" bIns="60933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000"/>
                    </a:pPr>
                    <a:r>
                      <a:rPr lang="en-US" sz="1333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10 µm</a:t>
                    </a:r>
                    <a:endParaRPr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  <p:sp>
                <p:nvSpPr>
                  <p:cNvPr id="729" name="Google Shape;729;p10"/>
                  <p:cNvSpPr txBox="1"/>
                  <p:nvPr/>
                </p:nvSpPr>
                <p:spPr>
                  <a:xfrm>
                    <a:off x="3517859" y="4274082"/>
                    <a:ext cx="512242" cy="320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spcFirstLastPara="1" wrap="square" lIns="121900" tIns="121900" rIns="121900" bIns="121900" anchor="t" anchorCtr="0">
                    <a:spAutoFit/>
                  </a:bodyPr>
                  <a:lstStyle/>
                  <a:p>
                    <a:pPr>
                      <a:buClr>
                        <a:srgbClr val="000000"/>
                      </a:buClr>
                      <a:buSzPts val="1100"/>
                    </a:pPr>
                    <a:r>
                      <a:rPr lang="en-US" sz="1467" b="1">
                        <a:solidFill>
                          <a:schemeClr val="lt1"/>
                        </a:solidFill>
                        <a:latin typeface="Arial"/>
                        <a:ea typeface="Arial"/>
                        <a:cs typeface="Arial"/>
                        <a:sym typeface="Arial"/>
                      </a:rPr>
                      <a:t>TLI</a:t>
                    </a:r>
                    <a:endParaRPr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endParaRPr>
                  </a:p>
                </p:txBody>
              </p:sp>
            </p:grpSp>
            <p:sp>
              <p:nvSpPr>
                <p:cNvPr id="730" name="Google Shape;730;p10"/>
                <p:cNvSpPr/>
                <p:nvPr/>
              </p:nvSpPr>
              <p:spPr>
                <a:xfrm>
                  <a:off x="2074127" y="3560164"/>
                  <a:ext cx="234357" cy="194080"/>
                </a:xfrm>
                <a:prstGeom prst="ellipse">
                  <a:avLst/>
                </a:prstGeom>
                <a:solidFill>
                  <a:schemeClr val="dk1"/>
                </a:solidFill>
                <a:ln>
                  <a:noFill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31" name="Google Shape;731;p10"/>
                <p:cNvSpPr/>
                <p:nvPr/>
              </p:nvSpPr>
              <p:spPr>
                <a:xfrm>
                  <a:off x="4234721" y="3582649"/>
                  <a:ext cx="164892" cy="164892"/>
                </a:xfrm>
                <a:prstGeom prst="ellipse">
                  <a:avLst/>
                </a:prstGeom>
                <a:solidFill>
                  <a:srgbClr val="7F7F7F"/>
                </a:solidFill>
                <a:ln>
                  <a:noFill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32" name="Google Shape;732;p10"/>
                <p:cNvSpPr/>
                <p:nvPr/>
              </p:nvSpPr>
              <p:spPr>
                <a:xfrm>
                  <a:off x="3170420" y="3570156"/>
                  <a:ext cx="197370" cy="184879"/>
                </a:xfrm>
                <a:prstGeom prst="ellipse">
                  <a:avLst/>
                </a:prstGeom>
                <a:solidFill>
                  <a:srgbClr val="BCBCBC"/>
                </a:solidFill>
                <a:ln>
                  <a:noFill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sp>
            <p:nvSpPr>
              <p:cNvPr id="733" name="Google Shape;733;p10"/>
              <p:cNvSpPr/>
              <p:nvPr/>
            </p:nvSpPr>
            <p:spPr>
              <a:xfrm>
                <a:off x="990156" y="3900836"/>
                <a:ext cx="315077" cy="267709"/>
              </a:xfrm>
              <a:custGeom>
                <a:avLst/>
                <a:gdLst/>
                <a:ahLst/>
                <a:cxnLst/>
                <a:rect l="l" t="t" r="r" b="b"/>
                <a:pathLst>
                  <a:path w="374684" h="536604" extrusionOk="0">
                    <a:moveTo>
                      <a:pt x="196435" y="812"/>
                    </a:moveTo>
                    <a:cubicBezTo>
                      <a:pt x="161029" y="6970"/>
                      <a:pt x="94835" y="36218"/>
                      <a:pt x="67126" y="65466"/>
                    </a:cubicBezTo>
                    <a:cubicBezTo>
                      <a:pt x="39417" y="94714"/>
                      <a:pt x="39417" y="139357"/>
                      <a:pt x="30181" y="176302"/>
                    </a:cubicBezTo>
                    <a:cubicBezTo>
                      <a:pt x="20945" y="213247"/>
                      <a:pt x="16326" y="254812"/>
                      <a:pt x="11708" y="287139"/>
                    </a:cubicBezTo>
                    <a:cubicBezTo>
                      <a:pt x="7090" y="319466"/>
                      <a:pt x="-5225" y="337939"/>
                      <a:pt x="2472" y="370266"/>
                    </a:cubicBezTo>
                    <a:cubicBezTo>
                      <a:pt x="10169" y="402593"/>
                      <a:pt x="37878" y="453393"/>
                      <a:pt x="57890" y="481102"/>
                    </a:cubicBezTo>
                    <a:cubicBezTo>
                      <a:pt x="77902" y="508811"/>
                      <a:pt x="90217" y="534982"/>
                      <a:pt x="122544" y="536521"/>
                    </a:cubicBezTo>
                    <a:cubicBezTo>
                      <a:pt x="154871" y="538060"/>
                      <a:pt x="221065" y="518048"/>
                      <a:pt x="251853" y="490339"/>
                    </a:cubicBezTo>
                    <a:cubicBezTo>
                      <a:pt x="282641" y="462630"/>
                      <a:pt x="288799" y="401054"/>
                      <a:pt x="307272" y="370266"/>
                    </a:cubicBezTo>
                    <a:cubicBezTo>
                      <a:pt x="325745" y="339478"/>
                      <a:pt x="351914" y="345636"/>
                      <a:pt x="362690" y="305612"/>
                    </a:cubicBezTo>
                    <a:cubicBezTo>
                      <a:pt x="373466" y="265588"/>
                      <a:pt x="378084" y="173224"/>
                      <a:pt x="371926" y="130121"/>
                    </a:cubicBezTo>
                    <a:cubicBezTo>
                      <a:pt x="365768" y="87018"/>
                      <a:pt x="341138" y="63926"/>
                      <a:pt x="325744" y="46993"/>
                    </a:cubicBezTo>
                    <a:cubicBezTo>
                      <a:pt x="310350" y="30060"/>
                      <a:pt x="296495" y="31600"/>
                      <a:pt x="279562" y="28521"/>
                    </a:cubicBezTo>
                    <a:cubicBezTo>
                      <a:pt x="262629" y="25442"/>
                      <a:pt x="231841" y="-5346"/>
                      <a:pt x="196435" y="812"/>
                    </a:cubicBezTo>
                    <a:close/>
                  </a:path>
                </a:pathLst>
              </a:custGeom>
              <a:noFill/>
              <a:ln w="9525" cap="flat" cmpd="sng">
                <a:solidFill>
                  <a:schemeClr val="bg1"/>
                </a:solidFill>
                <a:prstDash val="dash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34" name="Google Shape;734;p10"/>
              <p:cNvSpPr/>
              <p:nvPr/>
            </p:nvSpPr>
            <p:spPr>
              <a:xfrm>
                <a:off x="2307297" y="3079684"/>
                <a:ext cx="414104" cy="332959"/>
              </a:xfrm>
              <a:custGeom>
                <a:avLst/>
                <a:gdLst/>
                <a:ahLst/>
                <a:cxnLst/>
                <a:rect l="l" t="t" r="r" b="b"/>
                <a:pathLst>
                  <a:path w="382360" h="325957" extrusionOk="0">
                    <a:moveTo>
                      <a:pt x="97454" y="13832"/>
                    </a:moveTo>
                    <a:cubicBezTo>
                      <a:pt x="61228" y="38816"/>
                      <a:pt x="-1231" y="106272"/>
                      <a:pt x="18" y="156239"/>
                    </a:cubicBezTo>
                    <a:cubicBezTo>
                      <a:pt x="1267" y="206206"/>
                      <a:pt x="48736" y="291150"/>
                      <a:pt x="104949" y="313635"/>
                    </a:cubicBezTo>
                    <a:cubicBezTo>
                      <a:pt x="161162" y="336120"/>
                      <a:pt x="291077" y="327376"/>
                      <a:pt x="337297" y="291150"/>
                    </a:cubicBezTo>
                    <a:cubicBezTo>
                      <a:pt x="383517" y="254924"/>
                      <a:pt x="381018" y="139999"/>
                      <a:pt x="382267" y="96278"/>
                    </a:cubicBezTo>
                    <a:cubicBezTo>
                      <a:pt x="383516" y="52557"/>
                      <a:pt x="372274" y="43812"/>
                      <a:pt x="344792" y="28822"/>
                    </a:cubicBezTo>
                    <a:cubicBezTo>
                      <a:pt x="317310" y="13832"/>
                      <a:pt x="264845" y="7586"/>
                      <a:pt x="217376" y="6337"/>
                    </a:cubicBezTo>
                    <a:cubicBezTo>
                      <a:pt x="169907" y="5088"/>
                      <a:pt x="133680" y="-11152"/>
                      <a:pt x="97454" y="13832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35" name="Google Shape;735;p10"/>
              <p:cNvSpPr/>
              <p:nvPr/>
            </p:nvSpPr>
            <p:spPr>
              <a:xfrm>
                <a:off x="2127881" y="3884750"/>
                <a:ext cx="356112" cy="307666"/>
              </a:xfrm>
              <a:custGeom>
                <a:avLst/>
                <a:gdLst/>
                <a:ahLst/>
                <a:cxnLst/>
                <a:rect l="l" t="t" r="r" b="b"/>
                <a:pathLst>
                  <a:path w="374684" h="536604" extrusionOk="0">
                    <a:moveTo>
                      <a:pt x="196435" y="812"/>
                    </a:moveTo>
                    <a:cubicBezTo>
                      <a:pt x="161029" y="6970"/>
                      <a:pt x="94835" y="36218"/>
                      <a:pt x="67126" y="65466"/>
                    </a:cubicBezTo>
                    <a:cubicBezTo>
                      <a:pt x="39417" y="94714"/>
                      <a:pt x="39417" y="139357"/>
                      <a:pt x="30181" y="176302"/>
                    </a:cubicBezTo>
                    <a:cubicBezTo>
                      <a:pt x="20945" y="213247"/>
                      <a:pt x="16326" y="254812"/>
                      <a:pt x="11708" y="287139"/>
                    </a:cubicBezTo>
                    <a:cubicBezTo>
                      <a:pt x="7090" y="319466"/>
                      <a:pt x="-5225" y="337939"/>
                      <a:pt x="2472" y="370266"/>
                    </a:cubicBezTo>
                    <a:cubicBezTo>
                      <a:pt x="10169" y="402593"/>
                      <a:pt x="37878" y="453393"/>
                      <a:pt x="57890" y="481102"/>
                    </a:cubicBezTo>
                    <a:cubicBezTo>
                      <a:pt x="77902" y="508811"/>
                      <a:pt x="90217" y="534982"/>
                      <a:pt x="122544" y="536521"/>
                    </a:cubicBezTo>
                    <a:cubicBezTo>
                      <a:pt x="154871" y="538060"/>
                      <a:pt x="221065" y="518048"/>
                      <a:pt x="251853" y="490339"/>
                    </a:cubicBezTo>
                    <a:cubicBezTo>
                      <a:pt x="282641" y="462630"/>
                      <a:pt x="288799" y="401054"/>
                      <a:pt x="307272" y="370266"/>
                    </a:cubicBezTo>
                    <a:cubicBezTo>
                      <a:pt x="325745" y="339478"/>
                      <a:pt x="351914" y="345636"/>
                      <a:pt x="362690" y="305612"/>
                    </a:cubicBezTo>
                    <a:cubicBezTo>
                      <a:pt x="373466" y="265588"/>
                      <a:pt x="378084" y="173224"/>
                      <a:pt x="371926" y="130121"/>
                    </a:cubicBezTo>
                    <a:cubicBezTo>
                      <a:pt x="365768" y="87018"/>
                      <a:pt x="341138" y="63926"/>
                      <a:pt x="325744" y="46993"/>
                    </a:cubicBezTo>
                    <a:cubicBezTo>
                      <a:pt x="310350" y="30060"/>
                      <a:pt x="296495" y="31600"/>
                      <a:pt x="279562" y="28521"/>
                    </a:cubicBezTo>
                    <a:cubicBezTo>
                      <a:pt x="262629" y="25442"/>
                      <a:pt x="231841" y="-5346"/>
                      <a:pt x="196435" y="812"/>
                    </a:cubicBezTo>
                    <a:close/>
                  </a:path>
                </a:pathLst>
              </a:custGeom>
              <a:noFill/>
              <a:ln w="9525" cap="flat" cmpd="sng">
                <a:solidFill>
                  <a:schemeClr val="bg1"/>
                </a:solidFill>
                <a:prstDash val="dash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36" name="Google Shape;736;p10"/>
              <p:cNvSpPr/>
              <p:nvPr/>
            </p:nvSpPr>
            <p:spPr>
              <a:xfrm>
                <a:off x="3290077" y="3903315"/>
                <a:ext cx="356112" cy="278491"/>
              </a:xfrm>
              <a:custGeom>
                <a:avLst/>
                <a:gdLst/>
                <a:ahLst/>
                <a:cxnLst/>
                <a:rect l="l" t="t" r="r" b="b"/>
                <a:pathLst>
                  <a:path w="374684" h="536604" extrusionOk="0">
                    <a:moveTo>
                      <a:pt x="196435" y="812"/>
                    </a:moveTo>
                    <a:cubicBezTo>
                      <a:pt x="161029" y="6970"/>
                      <a:pt x="94835" y="36218"/>
                      <a:pt x="67126" y="65466"/>
                    </a:cubicBezTo>
                    <a:cubicBezTo>
                      <a:pt x="39417" y="94714"/>
                      <a:pt x="39417" y="139357"/>
                      <a:pt x="30181" y="176302"/>
                    </a:cubicBezTo>
                    <a:cubicBezTo>
                      <a:pt x="20945" y="213247"/>
                      <a:pt x="16326" y="254812"/>
                      <a:pt x="11708" y="287139"/>
                    </a:cubicBezTo>
                    <a:cubicBezTo>
                      <a:pt x="7090" y="319466"/>
                      <a:pt x="-5225" y="337939"/>
                      <a:pt x="2472" y="370266"/>
                    </a:cubicBezTo>
                    <a:cubicBezTo>
                      <a:pt x="10169" y="402593"/>
                      <a:pt x="37878" y="453393"/>
                      <a:pt x="57890" y="481102"/>
                    </a:cubicBezTo>
                    <a:cubicBezTo>
                      <a:pt x="77902" y="508811"/>
                      <a:pt x="90217" y="534982"/>
                      <a:pt x="122544" y="536521"/>
                    </a:cubicBezTo>
                    <a:cubicBezTo>
                      <a:pt x="154871" y="538060"/>
                      <a:pt x="221065" y="518048"/>
                      <a:pt x="251853" y="490339"/>
                    </a:cubicBezTo>
                    <a:cubicBezTo>
                      <a:pt x="282641" y="462630"/>
                      <a:pt x="288799" y="401054"/>
                      <a:pt x="307272" y="370266"/>
                    </a:cubicBezTo>
                    <a:cubicBezTo>
                      <a:pt x="325745" y="339478"/>
                      <a:pt x="351914" y="345636"/>
                      <a:pt x="362690" y="305612"/>
                    </a:cubicBezTo>
                    <a:cubicBezTo>
                      <a:pt x="373466" y="265588"/>
                      <a:pt x="378084" y="173224"/>
                      <a:pt x="371926" y="130121"/>
                    </a:cubicBezTo>
                    <a:cubicBezTo>
                      <a:pt x="365768" y="87018"/>
                      <a:pt x="341138" y="63926"/>
                      <a:pt x="325744" y="46993"/>
                    </a:cubicBezTo>
                    <a:cubicBezTo>
                      <a:pt x="310350" y="30060"/>
                      <a:pt x="296495" y="31600"/>
                      <a:pt x="279562" y="28521"/>
                    </a:cubicBezTo>
                    <a:cubicBezTo>
                      <a:pt x="262629" y="25442"/>
                      <a:pt x="231841" y="-5346"/>
                      <a:pt x="196435" y="812"/>
                    </a:cubicBezTo>
                    <a:close/>
                  </a:path>
                </a:pathLst>
              </a:custGeom>
              <a:noFill/>
              <a:ln w="9525" cap="flat" cmpd="sng">
                <a:solidFill>
                  <a:schemeClr val="bg1"/>
                </a:solidFill>
                <a:prstDash val="dash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37" name="Google Shape;737;p10"/>
              <p:cNvSpPr/>
              <p:nvPr/>
            </p:nvSpPr>
            <p:spPr>
              <a:xfrm>
                <a:off x="1158904" y="3026637"/>
                <a:ext cx="414104" cy="332959"/>
              </a:xfrm>
              <a:custGeom>
                <a:avLst/>
                <a:gdLst/>
                <a:ahLst/>
                <a:cxnLst/>
                <a:rect l="l" t="t" r="r" b="b"/>
                <a:pathLst>
                  <a:path w="382360" h="325957" extrusionOk="0">
                    <a:moveTo>
                      <a:pt x="97454" y="13832"/>
                    </a:moveTo>
                    <a:cubicBezTo>
                      <a:pt x="61228" y="38816"/>
                      <a:pt x="-1231" y="106272"/>
                      <a:pt x="18" y="156239"/>
                    </a:cubicBezTo>
                    <a:cubicBezTo>
                      <a:pt x="1267" y="206206"/>
                      <a:pt x="48736" y="291150"/>
                      <a:pt x="104949" y="313635"/>
                    </a:cubicBezTo>
                    <a:cubicBezTo>
                      <a:pt x="161162" y="336120"/>
                      <a:pt x="291077" y="327376"/>
                      <a:pt x="337297" y="291150"/>
                    </a:cubicBezTo>
                    <a:cubicBezTo>
                      <a:pt x="383517" y="254924"/>
                      <a:pt x="381018" y="139999"/>
                      <a:pt x="382267" y="96278"/>
                    </a:cubicBezTo>
                    <a:cubicBezTo>
                      <a:pt x="383516" y="52557"/>
                      <a:pt x="372274" y="43812"/>
                      <a:pt x="344792" y="28822"/>
                    </a:cubicBezTo>
                    <a:cubicBezTo>
                      <a:pt x="317310" y="13832"/>
                      <a:pt x="264845" y="7586"/>
                      <a:pt x="217376" y="6337"/>
                    </a:cubicBezTo>
                    <a:cubicBezTo>
                      <a:pt x="169907" y="5088"/>
                      <a:pt x="133680" y="-11152"/>
                      <a:pt x="97454" y="13832"/>
                    </a:cubicBezTo>
                    <a:close/>
                  </a:path>
                </a:pathLst>
              </a:custGeom>
              <a:noFill/>
              <a:ln w="15875" cap="flat" cmpd="sng">
                <a:solidFill>
                  <a:schemeClr val="lt1"/>
                </a:solidFill>
                <a:prstDash val="sys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38" name="Google Shape;738;p10"/>
              <p:cNvSpPr/>
              <p:nvPr/>
            </p:nvSpPr>
            <p:spPr>
              <a:xfrm>
                <a:off x="3505379" y="3116814"/>
                <a:ext cx="414104" cy="332959"/>
              </a:xfrm>
              <a:custGeom>
                <a:avLst/>
                <a:gdLst/>
                <a:ahLst/>
                <a:cxnLst/>
                <a:rect l="l" t="t" r="r" b="b"/>
                <a:pathLst>
                  <a:path w="382360" h="325957" extrusionOk="0">
                    <a:moveTo>
                      <a:pt x="97454" y="13832"/>
                    </a:moveTo>
                    <a:cubicBezTo>
                      <a:pt x="61228" y="38816"/>
                      <a:pt x="-1231" y="106272"/>
                      <a:pt x="18" y="156239"/>
                    </a:cubicBezTo>
                    <a:cubicBezTo>
                      <a:pt x="1267" y="206206"/>
                      <a:pt x="48736" y="291150"/>
                      <a:pt x="104949" y="313635"/>
                    </a:cubicBezTo>
                    <a:cubicBezTo>
                      <a:pt x="161162" y="336120"/>
                      <a:pt x="291077" y="327376"/>
                      <a:pt x="337297" y="291150"/>
                    </a:cubicBezTo>
                    <a:cubicBezTo>
                      <a:pt x="383517" y="254924"/>
                      <a:pt x="381018" y="139999"/>
                      <a:pt x="382267" y="96278"/>
                    </a:cubicBezTo>
                    <a:cubicBezTo>
                      <a:pt x="383516" y="52557"/>
                      <a:pt x="372274" y="43812"/>
                      <a:pt x="344792" y="28822"/>
                    </a:cubicBezTo>
                    <a:cubicBezTo>
                      <a:pt x="317310" y="13832"/>
                      <a:pt x="264845" y="7586"/>
                      <a:pt x="217376" y="6337"/>
                    </a:cubicBezTo>
                    <a:cubicBezTo>
                      <a:pt x="169907" y="5088"/>
                      <a:pt x="133680" y="-11152"/>
                      <a:pt x="97454" y="13832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39" name="Google Shape;739;p10"/>
              <p:cNvSpPr/>
              <p:nvPr/>
            </p:nvSpPr>
            <p:spPr>
              <a:xfrm>
                <a:off x="1210989" y="2009710"/>
                <a:ext cx="253314" cy="252307"/>
              </a:xfrm>
              <a:custGeom>
                <a:avLst/>
                <a:gdLst/>
                <a:ahLst/>
                <a:cxnLst/>
                <a:rect l="l" t="t" r="r" b="b"/>
                <a:pathLst>
                  <a:path w="229254" h="237664" extrusionOk="0">
                    <a:moveTo>
                      <a:pt x="220205" y="2377"/>
                    </a:moveTo>
                    <a:cubicBezTo>
                      <a:pt x="205215" y="-7616"/>
                      <a:pt x="153998" y="16118"/>
                      <a:pt x="130264" y="32357"/>
                    </a:cubicBezTo>
                    <a:cubicBezTo>
                      <a:pt x="106530" y="48596"/>
                      <a:pt x="99034" y="79826"/>
                      <a:pt x="77798" y="99813"/>
                    </a:cubicBezTo>
                    <a:cubicBezTo>
                      <a:pt x="56562" y="119800"/>
                      <a:pt x="11591" y="129794"/>
                      <a:pt x="2847" y="152279"/>
                    </a:cubicBezTo>
                    <a:cubicBezTo>
                      <a:pt x="-5897" y="174764"/>
                      <a:pt x="6595" y="224732"/>
                      <a:pt x="25333" y="234725"/>
                    </a:cubicBezTo>
                    <a:cubicBezTo>
                      <a:pt x="44071" y="244718"/>
                      <a:pt x="89041" y="227229"/>
                      <a:pt x="115274" y="212239"/>
                    </a:cubicBezTo>
                    <a:cubicBezTo>
                      <a:pt x="141507" y="197249"/>
                      <a:pt x="165241" y="164771"/>
                      <a:pt x="182729" y="144784"/>
                    </a:cubicBezTo>
                    <a:cubicBezTo>
                      <a:pt x="200217" y="124797"/>
                      <a:pt x="211461" y="108557"/>
                      <a:pt x="220205" y="92318"/>
                    </a:cubicBezTo>
                    <a:cubicBezTo>
                      <a:pt x="228949" y="76079"/>
                      <a:pt x="235195" y="12370"/>
                      <a:pt x="220205" y="2377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0" name="Google Shape;740;p10"/>
              <p:cNvSpPr/>
              <p:nvPr/>
            </p:nvSpPr>
            <p:spPr>
              <a:xfrm>
                <a:off x="3590592" y="2028277"/>
                <a:ext cx="253314" cy="252307"/>
              </a:xfrm>
              <a:custGeom>
                <a:avLst/>
                <a:gdLst/>
                <a:ahLst/>
                <a:cxnLst/>
                <a:rect l="l" t="t" r="r" b="b"/>
                <a:pathLst>
                  <a:path w="229254" h="237664" extrusionOk="0">
                    <a:moveTo>
                      <a:pt x="220205" y="2377"/>
                    </a:moveTo>
                    <a:cubicBezTo>
                      <a:pt x="205215" y="-7616"/>
                      <a:pt x="153998" y="16118"/>
                      <a:pt x="130264" y="32357"/>
                    </a:cubicBezTo>
                    <a:cubicBezTo>
                      <a:pt x="106530" y="48596"/>
                      <a:pt x="99034" y="79826"/>
                      <a:pt x="77798" y="99813"/>
                    </a:cubicBezTo>
                    <a:cubicBezTo>
                      <a:pt x="56562" y="119800"/>
                      <a:pt x="11591" y="129794"/>
                      <a:pt x="2847" y="152279"/>
                    </a:cubicBezTo>
                    <a:cubicBezTo>
                      <a:pt x="-5897" y="174764"/>
                      <a:pt x="6595" y="224732"/>
                      <a:pt x="25333" y="234725"/>
                    </a:cubicBezTo>
                    <a:cubicBezTo>
                      <a:pt x="44071" y="244718"/>
                      <a:pt x="89041" y="227229"/>
                      <a:pt x="115274" y="212239"/>
                    </a:cubicBezTo>
                    <a:cubicBezTo>
                      <a:pt x="141507" y="197249"/>
                      <a:pt x="165241" y="164771"/>
                      <a:pt x="182729" y="144784"/>
                    </a:cubicBezTo>
                    <a:cubicBezTo>
                      <a:pt x="200217" y="124797"/>
                      <a:pt x="211461" y="108557"/>
                      <a:pt x="220205" y="92318"/>
                    </a:cubicBezTo>
                    <a:cubicBezTo>
                      <a:pt x="228949" y="76079"/>
                      <a:pt x="235195" y="12370"/>
                      <a:pt x="220205" y="2377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1" name="Google Shape;741;p10"/>
              <p:cNvSpPr/>
              <p:nvPr/>
            </p:nvSpPr>
            <p:spPr>
              <a:xfrm>
                <a:off x="2417354" y="1983187"/>
                <a:ext cx="253314" cy="252307"/>
              </a:xfrm>
              <a:custGeom>
                <a:avLst/>
                <a:gdLst/>
                <a:ahLst/>
                <a:cxnLst/>
                <a:rect l="l" t="t" r="r" b="b"/>
                <a:pathLst>
                  <a:path w="229254" h="237664" extrusionOk="0">
                    <a:moveTo>
                      <a:pt x="220205" y="2377"/>
                    </a:moveTo>
                    <a:cubicBezTo>
                      <a:pt x="205215" y="-7616"/>
                      <a:pt x="153998" y="16118"/>
                      <a:pt x="130264" y="32357"/>
                    </a:cubicBezTo>
                    <a:cubicBezTo>
                      <a:pt x="106530" y="48596"/>
                      <a:pt x="99034" y="79826"/>
                      <a:pt x="77798" y="99813"/>
                    </a:cubicBezTo>
                    <a:cubicBezTo>
                      <a:pt x="56562" y="119800"/>
                      <a:pt x="11591" y="129794"/>
                      <a:pt x="2847" y="152279"/>
                    </a:cubicBezTo>
                    <a:cubicBezTo>
                      <a:pt x="-5897" y="174764"/>
                      <a:pt x="6595" y="224732"/>
                      <a:pt x="25333" y="234725"/>
                    </a:cubicBezTo>
                    <a:cubicBezTo>
                      <a:pt x="44071" y="244718"/>
                      <a:pt x="89041" y="227229"/>
                      <a:pt x="115274" y="212239"/>
                    </a:cubicBezTo>
                    <a:cubicBezTo>
                      <a:pt x="141507" y="197249"/>
                      <a:pt x="165241" y="164771"/>
                      <a:pt x="182729" y="144784"/>
                    </a:cubicBezTo>
                    <a:cubicBezTo>
                      <a:pt x="200217" y="124797"/>
                      <a:pt x="211461" y="108557"/>
                      <a:pt x="220205" y="92318"/>
                    </a:cubicBezTo>
                    <a:cubicBezTo>
                      <a:pt x="228949" y="76079"/>
                      <a:pt x="235195" y="12370"/>
                      <a:pt x="220205" y="2377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2" name="Google Shape;742;p10"/>
              <p:cNvSpPr/>
              <p:nvPr/>
            </p:nvSpPr>
            <p:spPr>
              <a:xfrm>
                <a:off x="3425080" y="952570"/>
                <a:ext cx="299734" cy="242292"/>
              </a:xfrm>
              <a:custGeom>
                <a:avLst/>
                <a:gdLst/>
                <a:ahLst/>
                <a:cxnLst/>
                <a:rect l="l" t="t" r="r" b="b"/>
                <a:pathLst>
                  <a:path w="271265" h="228230" extrusionOk="0">
                    <a:moveTo>
                      <a:pt x="67694" y="8814"/>
                    </a:moveTo>
                    <a:cubicBezTo>
                      <a:pt x="37714" y="25053"/>
                      <a:pt x="-3509" y="71273"/>
                      <a:pt x="238" y="106250"/>
                    </a:cubicBezTo>
                    <a:cubicBezTo>
                      <a:pt x="3985" y="141227"/>
                      <a:pt x="58950" y="199939"/>
                      <a:pt x="90179" y="218677"/>
                    </a:cubicBezTo>
                    <a:cubicBezTo>
                      <a:pt x="121408" y="237415"/>
                      <a:pt x="160133" y="223674"/>
                      <a:pt x="187615" y="218677"/>
                    </a:cubicBezTo>
                    <a:cubicBezTo>
                      <a:pt x="215097" y="213680"/>
                      <a:pt x="241330" y="209932"/>
                      <a:pt x="255071" y="188696"/>
                    </a:cubicBezTo>
                    <a:cubicBezTo>
                      <a:pt x="268812" y="167460"/>
                      <a:pt x="273808" y="114994"/>
                      <a:pt x="270061" y="91260"/>
                    </a:cubicBezTo>
                    <a:cubicBezTo>
                      <a:pt x="266314" y="67526"/>
                      <a:pt x="247576" y="60031"/>
                      <a:pt x="232586" y="46290"/>
                    </a:cubicBezTo>
                    <a:cubicBezTo>
                      <a:pt x="217596" y="32549"/>
                      <a:pt x="206353" y="15060"/>
                      <a:pt x="180120" y="8814"/>
                    </a:cubicBezTo>
                    <a:cubicBezTo>
                      <a:pt x="153887" y="2568"/>
                      <a:pt x="97674" y="-7425"/>
                      <a:pt x="67694" y="8814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3" name="Google Shape;743;p10"/>
              <p:cNvSpPr/>
              <p:nvPr/>
            </p:nvSpPr>
            <p:spPr>
              <a:xfrm>
                <a:off x="3210021" y="2282766"/>
                <a:ext cx="224223" cy="246754"/>
              </a:xfrm>
              <a:custGeom>
                <a:avLst/>
                <a:gdLst/>
                <a:ahLst/>
                <a:cxnLst/>
                <a:rect l="l" t="t" r="r" b="b"/>
                <a:pathLst>
                  <a:path w="168327" h="233312" extrusionOk="0">
                    <a:moveTo>
                      <a:pt x="137788" y="143285"/>
                    </a:moveTo>
                    <a:cubicBezTo>
                      <a:pt x="144034" y="119550"/>
                      <a:pt x="132791" y="80826"/>
                      <a:pt x="137788" y="60839"/>
                    </a:cubicBezTo>
                    <a:cubicBezTo>
                      <a:pt x="142785" y="40852"/>
                      <a:pt x="172765" y="33357"/>
                      <a:pt x="167768" y="23364"/>
                    </a:cubicBezTo>
                    <a:cubicBezTo>
                      <a:pt x="162771" y="13371"/>
                      <a:pt x="129044" y="-4118"/>
                      <a:pt x="107808" y="879"/>
                    </a:cubicBezTo>
                    <a:cubicBezTo>
                      <a:pt x="86572" y="5876"/>
                      <a:pt x="55342" y="35856"/>
                      <a:pt x="40352" y="53344"/>
                    </a:cubicBezTo>
                    <a:cubicBezTo>
                      <a:pt x="25362" y="70832"/>
                      <a:pt x="22864" y="87072"/>
                      <a:pt x="17867" y="105810"/>
                    </a:cubicBezTo>
                    <a:cubicBezTo>
                      <a:pt x="12870" y="124548"/>
                      <a:pt x="12870" y="148283"/>
                      <a:pt x="10372" y="165771"/>
                    </a:cubicBezTo>
                    <a:cubicBezTo>
                      <a:pt x="7874" y="183260"/>
                      <a:pt x="-5867" y="199499"/>
                      <a:pt x="2877" y="210741"/>
                    </a:cubicBezTo>
                    <a:cubicBezTo>
                      <a:pt x="11621" y="221983"/>
                      <a:pt x="46598" y="234475"/>
                      <a:pt x="62837" y="233226"/>
                    </a:cubicBezTo>
                    <a:cubicBezTo>
                      <a:pt x="79076" y="231977"/>
                      <a:pt x="87821" y="214489"/>
                      <a:pt x="100313" y="203246"/>
                    </a:cubicBezTo>
                    <a:cubicBezTo>
                      <a:pt x="112805" y="192004"/>
                      <a:pt x="131542" y="167020"/>
                      <a:pt x="137788" y="143285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4" name="Google Shape;744;p10"/>
              <p:cNvSpPr/>
              <p:nvPr/>
            </p:nvSpPr>
            <p:spPr>
              <a:xfrm>
                <a:off x="1987093" y="2237678"/>
                <a:ext cx="224223" cy="246754"/>
              </a:xfrm>
              <a:custGeom>
                <a:avLst/>
                <a:gdLst/>
                <a:ahLst/>
                <a:cxnLst/>
                <a:rect l="l" t="t" r="r" b="b"/>
                <a:pathLst>
                  <a:path w="168327" h="233312" extrusionOk="0">
                    <a:moveTo>
                      <a:pt x="137788" y="143285"/>
                    </a:moveTo>
                    <a:cubicBezTo>
                      <a:pt x="144034" y="119550"/>
                      <a:pt x="132791" y="80826"/>
                      <a:pt x="137788" y="60839"/>
                    </a:cubicBezTo>
                    <a:cubicBezTo>
                      <a:pt x="142785" y="40852"/>
                      <a:pt x="172765" y="33357"/>
                      <a:pt x="167768" y="23364"/>
                    </a:cubicBezTo>
                    <a:cubicBezTo>
                      <a:pt x="162771" y="13371"/>
                      <a:pt x="129044" y="-4118"/>
                      <a:pt x="107808" y="879"/>
                    </a:cubicBezTo>
                    <a:cubicBezTo>
                      <a:pt x="86572" y="5876"/>
                      <a:pt x="55342" y="35856"/>
                      <a:pt x="40352" y="53344"/>
                    </a:cubicBezTo>
                    <a:cubicBezTo>
                      <a:pt x="25362" y="70832"/>
                      <a:pt x="22864" y="87072"/>
                      <a:pt x="17867" y="105810"/>
                    </a:cubicBezTo>
                    <a:cubicBezTo>
                      <a:pt x="12870" y="124548"/>
                      <a:pt x="12870" y="148283"/>
                      <a:pt x="10372" y="165771"/>
                    </a:cubicBezTo>
                    <a:cubicBezTo>
                      <a:pt x="7874" y="183260"/>
                      <a:pt x="-5867" y="199499"/>
                      <a:pt x="2877" y="210741"/>
                    </a:cubicBezTo>
                    <a:cubicBezTo>
                      <a:pt x="11621" y="221983"/>
                      <a:pt x="46598" y="234475"/>
                      <a:pt x="62837" y="233226"/>
                    </a:cubicBezTo>
                    <a:cubicBezTo>
                      <a:pt x="79076" y="231977"/>
                      <a:pt x="87821" y="214489"/>
                      <a:pt x="100313" y="203246"/>
                    </a:cubicBezTo>
                    <a:cubicBezTo>
                      <a:pt x="112805" y="192004"/>
                      <a:pt x="131542" y="167020"/>
                      <a:pt x="137788" y="143285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5" name="Google Shape;745;p10"/>
              <p:cNvSpPr/>
              <p:nvPr/>
            </p:nvSpPr>
            <p:spPr>
              <a:xfrm>
                <a:off x="838700" y="2256244"/>
                <a:ext cx="224223" cy="246754"/>
              </a:xfrm>
              <a:custGeom>
                <a:avLst/>
                <a:gdLst/>
                <a:ahLst/>
                <a:cxnLst/>
                <a:rect l="l" t="t" r="r" b="b"/>
                <a:pathLst>
                  <a:path w="168327" h="233312" extrusionOk="0">
                    <a:moveTo>
                      <a:pt x="137788" y="143285"/>
                    </a:moveTo>
                    <a:cubicBezTo>
                      <a:pt x="144034" y="119550"/>
                      <a:pt x="132791" y="80826"/>
                      <a:pt x="137788" y="60839"/>
                    </a:cubicBezTo>
                    <a:cubicBezTo>
                      <a:pt x="142785" y="40852"/>
                      <a:pt x="172765" y="33357"/>
                      <a:pt x="167768" y="23364"/>
                    </a:cubicBezTo>
                    <a:cubicBezTo>
                      <a:pt x="162771" y="13371"/>
                      <a:pt x="129044" y="-4118"/>
                      <a:pt x="107808" y="879"/>
                    </a:cubicBezTo>
                    <a:cubicBezTo>
                      <a:pt x="86572" y="5876"/>
                      <a:pt x="55342" y="35856"/>
                      <a:pt x="40352" y="53344"/>
                    </a:cubicBezTo>
                    <a:cubicBezTo>
                      <a:pt x="25362" y="70832"/>
                      <a:pt x="22864" y="87072"/>
                      <a:pt x="17867" y="105810"/>
                    </a:cubicBezTo>
                    <a:cubicBezTo>
                      <a:pt x="12870" y="124548"/>
                      <a:pt x="12870" y="148283"/>
                      <a:pt x="10372" y="165771"/>
                    </a:cubicBezTo>
                    <a:cubicBezTo>
                      <a:pt x="7874" y="183260"/>
                      <a:pt x="-5867" y="199499"/>
                      <a:pt x="2877" y="210741"/>
                    </a:cubicBezTo>
                    <a:cubicBezTo>
                      <a:pt x="11621" y="221983"/>
                      <a:pt x="46598" y="234475"/>
                      <a:pt x="62837" y="233226"/>
                    </a:cubicBezTo>
                    <a:cubicBezTo>
                      <a:pt x="79076" y="231977"/>
                      <a:pt x="87821" y="214489"/>
                      <a:pt x="100313" y="203246"/>
                    </a:cubicBezTo>
                    <a:cubicBezTo>
                      <a:pt x="112805" y="192004"/>
                      <a:pt x="131542" y="167020"/>
                      <a:pt x="137788" y="143285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6" name="Google Shape;746;p10"/>
              <p:cNvSpPr/>
              <p:nvPr/>
            </p:nvSpPr>
            <p:spPr>
              <a:xfrm>
                <a:off x="1037196" y="957874"/>
                <a:ext cx="299734" cy="242292"/>
              </a:xfrm>
              <a:custGeom>
                <a:avLst/>
                <a:gdLst/>
                <a:ahLst/>
                <a:cxnLst/>
                <a:rect l="l" t="t" r="r" b="b"/>
                <a:pathLst>
                  <a:path w="271265" h="228230" extrusionOk="0">
                    <a:moveTo>
                      <a:pt x="67694" y="8814"/>
                    </a:moveTo>
                    <a:cubicBezTo>
                      <a:pt x="37714" y="25053"/>
                      <a:pt x="-3509" y="71273"/>
                      <a:pt x="238" y="106250"/>
                    </a:cubicBezTo>
                    <a:cubicBezTo>
                      <a:pt x="3985" y="141227"/>
                      <a:pt x="58950" y="199939"/>
                      <a:pt x="90179" y="218677"/>
                    </a:cubicBezTo>
                    <a:cubicBezTo>
                      <a:pt x="121408" y="237415"/>
                      <a:pt x="160133" y="223674"/>
                      <a:pt x="187615" y="218677"/>
                    </a:cubicBezTo>
                    <a:cubicBezTo>
                      <a:pt x="215097" y="213680"/>
                      <a:pt x="241330" y="209932"/>
                      <a:pt x="255071" y="188696"/>
                    </a:cubicBezTo>
                    <a:cubicBezTo>
                      <a:pt x="268812" y="167460"/>
                      <a:pt x="273808" y="114994"/>
                      <a:pt x="270061" y="91260"/>
                    </a:cubicBezTo>
                    <a:cubicBezTo>
                      <a:pt x="266314" y="67526"/>
                      <a:pt x="247576" y="60031"/>
                      <a:pt x="232586" y="46290"/>
                    </a:cubicBezTo>
                    <a:cubicBezTo>
                      <a:pt x="217596" y="32549"/>
                      <a:pt x="206353" y="15060"/>
                      <a:pt x="180120" y="8814"/>
                    </a:cubicBezTo>
                    <a:cubicBezTo>
                      <a:pt x="153887" y="2568"/>
                      <a:pt x="97674" y="-7425"/>
                      <a:pt x="67694" y="8814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7" name="Google Shape;747;p10"/>
              <p:cNvSpPr/>
              <p:nvPr/>
            </p:nvSpPr>
            <p:spPr>
              <a:xfrm>
                <a:off x="2271166" y="941960"/>
                <a:ext cx="299734" cy="242292"/>
              </a:xfrm>
              <a:custGeom>
                <a:avLst/>
                <a:gdLst/>
                <a:ahLst/>
                <a:cxnLst/>
                <a:rect l="l" t="t" r="r" b="b"/>
                <a:pathLst>
                  <a:path w="271265" h="228230" extrusionOk="0">
                    <a:moveTo>
                      <a:pt x="67694" y="8814"/>
                    </a:moveTo>
                    <a:cubicBezTo>
                      <a:pt x="37714" y="25053"/>
                      <a:pt x="-3509" y="71273"/>
                      <a:pt x="238" y="106250"/>
                    </a:cubicBezTo>
                    <a:cubicBezTo>
                      <a:pt x="3985" y="141227"/>
                      <a:pt x="58950" y="199939"/>
                      <a:pt x="90179" y="218677"/>
                    </a:cubicBezTo>
                    <a:cubicBezTo>
                      <a:pt x="121408" y="237415"/>
                      <a:pt x="160133" y="223674"/>
                      <a:pt x="187615" y="218677"/>
                    </a:cubicBezTo>
                    <a:cubicBezTo>
                      <a:pt x="215097" y="213680"/>
                      <a:pt x="241330" y="209932"/>
                      <a:pt x="255071" y="188696"/>
                    </a:cubicBezTo>
                    <a:cubicBezTo>
                      <a:pt x="268812" y="167460"/>
                      <a:pt x="273808" y="114994"/>
                      <a:pt x="270061" y="91260"/>
                    </a:cubicBezTo>
                    <a:cubicBezTo>
                      <a:pt x="266314" y="67526"/>
                      <a:pt x="247576" y="60031"/>
                      <a:pt x="232586" y="46290"/>
                    </a:cubicBezTo>
                    <a:cubicBezTo>
                      <a:pt x="217596" y="32549"/>
                      <a:pt x="206353" y="15060"/>
                      <a:pt x="180120" y="8814"/>
                    </a:cubicBezTo>
                    <a:cubicBezTo>
                      <a:pt x="153887" y="2568"/>
                      <a:pt x="97674" y="-7425"/>
                      <a:pt x="67694" y="8814"/>
                    </a:cubicBezTo>
                    <a:close/>
                  </a:path>
                </a:pathLst>
              </a:custGeom>
              <a:noFill/>
              <a:ln w="12700" cap="flat" cmpd="sng">
                <a:solidFill>
                  <a:schemeClr val="lt1"/>
                </a:solidFill>
                <a:prstDash val="dot"/>
                <a:round/>
                <a:headEnd type="none" w="sm" len="sm"/>
                <a:tailEnd type="none" w="sm" len="sm"/>
              </a:ln>
            </p:spPr>
            <p:txBody>
              <a:bodyPr spcFirstLastPara="1" wrap="square" lIns="121900" tIns="60933" rIns="121900" bIns="60933" anchor="ctr" anchorCtr="0">
                <a:noAutofit/>
              </a:bodyPr>
              <a:lstStyle/>
              <a:p>
                <a:pPr algn="ctr">
                  <a:buClr>
                    <a:srgbClr val="000000"/>
                  </a:buClr>
                  <a:buSzPts val="1400"/>
                </a:pPr>
                <a:endParaRPr sz="1867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748" name="Google Shape;748;p10"/>
              <p:cNvSpPr txBox="1"/>
              <p:nvPr/>
            </p:nvSpPr>
            <p:spPr>
              <a:xfrm>
                <a:off x="949122" y="938056"/>
                <a:ext cx="583009" cy="2362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21900" tIns="60933" rIns="121900" bIns="60933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SzPts val="1000"/>
                </a:pPr>
                <a:r>
                  <a:rPr lang="en-US" sz="1333" dirty="0" err="1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Nuc</a:t>
                </a:r>
                <a:endParaRPr sz="1333" dirty="0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sp>
          <p:nvSpPr>
            <p:cNvPr id="750" name="Google Shape;750;p10"/>
            <p:cNvSpPr/>
            <p:nvPr/>
          </p:nvSpPr>
          <p:spPr>
            <a:xfrm>
              <a:off x="598682" y="378424"/>
              <a:ext cx="419347" cy="41037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400"/>
              </a:pPr>
              <a:r>
                <a:rPr lang="en-US" sz="1867" b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A</a:t>
              </a:r>
              <a:endParaRPr sz="1867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51" name="Google Shape;751;p10"/>
            <p:cNvSpPr/>
            <p:nvPr/>
          </p:nvSpPr>
          <p:spPr>
            <a:xfrm>
              <a:off x="600282" y="1839224"/>
              <a:ext cx="419347" cy="41037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400"/>
              </a:pPr>
              <a:r>
                <a:rPr lang="en-US" sz="1867" b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B</a:t>
              </a:r>
              <a:endParaRPr sz="1867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52" name="Google Shape;752;p10"/>
            <p:cNvSpPr/>
            <p:nvPr/>
          </p:nvSpPr>
          <p:spPr>
            <a:xfrm>
              <a:off x="600282" y="3327224"/>
              <a:ext cx="419347" cy="41037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400"/>
              </a:pPr>
              <a:r>
                <a:rPr lang="en-US" sz="1867" b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C</a:t>
              </a:r>
              <a:endParaRPr sz="1867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53" name="Google Shape;753;p10"/>
            <p:cNvSpPr/>
            <p:nvPr/>
          </p:nvSpPr>
          <p:spPr>
            <a:xfrm>
              <a:off x="611482" y="4845624"/>
              <a:ext cx="419347" cy="41037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400"/>
              </a:pPr>
              <a:r>
                <a:rPr lang="en-US" sz="1867" b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D</a:t>
              </a:r>
              <a:endParaRPr sz="1867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0" name="Google Shape;748;p10"/>
            <p:cNvSpPr txBox="1"/>
            <p:nvPr/>
          </p:nvSpPr>
          <p:spPr>
            <a:xfrm>
              <a:off x="1114278" y="2871462"/>
              <a:ext cx="828472" cy="3281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000"/>
              </a:pPr>
              <a:r>
                <a:rPr lang="en-US" sz="1333" dirty="0" err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Nuc</a:t>
              </a:r>
              <a:endParaRPr sz="1333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1" name="Google Shape;748;p10"/>
            <p:cNvSpPr txBox="1"/>
            <p:nvPr/>
          </p:nvSpPr>
          <p:spPr>
            <a:xfrm>
              <a:off x="1751587" y="4026007"/>
              <a:ext cx="828472" cy="3281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000"/>
              </a:pPr>
              <a:r>
                <a:rPr lang="en-US" sz="1333" dirty="0" err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Nuc</a:t>
              </a:r>
              <a:endParaRPr sz="1333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2" name="Google Shape;748;p10"/>
            <p:cNvSpPr txBox="1"/>
            <p:nvPr/>
          </p:nvSpPr>
          <p:spPr>
            <a:xfrm>
              <a:off x="1365056" y="5125993"/>
              <a:ext cx="828472" cy="3281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000"/>
              </a:pPr>
              <a:r>
                <a:rPr lang="en-US" sz="1333" dirty="0" err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Nuc</a:t>
              </a:r>
              <a:endParaRPr sz="1333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4" name="Google Shape;737;p10"/>
            <p:cNvSpPr/>
            <p:nvPr/>
          </p:nvSpPr>
          <p:spPr>
            <a:xfrm>
              <a:off x="3364157" y="3959229"/>
              <a:ext cx="588454" cy="462541"/>
            </a:xfrm>
            <a:custGeom>
              <a:avLst/>
              <a:gdLst/>
              <a:ahLst/>
              <a:cxnLst/>
              <a:rect l="l" t="t" r="r" b="b"/>
              <a:pathLst>
                <a:path w="382360" h="325957" extrusionOk="0">
                  <a:moveTo>
                    <a:pt x="97454" y="13832"/>
                  </a:moveTo>
                  <a:cubicBezTo>
                    <a:pt x="61228" y="38816"/>
                    <a:pt x="-1231" y="106272"/>
                    <a:pt x="18" y="156239"/>
                  </a:cubicBezTo>
                  <a:cubicBezTo>
                    <a:pt x="1267" y="206206"/>
                    <a:pt x="48736" y="291150"/>
                    <a:pt x="104949" y="313635"/>
                  </a:cubicBezTo>
                  <a:cubicBezTo>
                    <a:pt x="161162" y="336120"/>
                    <a:pt x="291077" y="327376"/>
                    <a:pt x="337297" y="291150"/>
                  </a:cubicBezTo>
                  <a:cubicBezTo>
                    <a:pt x="383517" y="254924"/>
                    <a:pt x="381018" y="139999"/>
                    <a:pt x="382267" y="96278"/>
                  </a:cubicBezTo>
                  <a:cubicBezTo>
                    <a:pt x="383516" y="52557"/>
                    <a:pt x="372274" y="43812"/>
                    <a:pt x="344792" y="28822"/>
                  </a:cubicBezTo>
                  <a:cubicBezTo>
                    <a:pt x="317310" y="13832"/>
                    <a:pt x="264845" y="7586"/>
                    <a:pt x="217376" y="6337"/>
                  </a:cubicBezTo>
                  <a:cubicBezTo>
                    <a:pt x="169907" y="5088"/>
                    <a:pt x="133680" y="-11152"/>
                    <a:pt x="97454" y="13832"/>
                  </a:cubicBezTo>
                  <a:close/>
                </a:path>
              </a:pathLst>
            </a:custGeom>
            <a:noFill/>
            <a:ln w="15875" cap="flat" cmpd="sng">
              <a:solidFill>
                <a:schemeClr val="lt1"/>
              </a:solidFill>
              <a:prstDash val="sysDot"/>
              <a:round/>
              <a:headEnd type="none" w="sm" len="sm"/>
              <a:tailEnd type="none" w="sm" len="sm"/>
            </a:ln>
          </p:spPr>
          <p:txBody>
            <a:bodyPr spcFirstLastPara="1" wrap="square" lIns="121900" tIns="60933" rIns="121900" bIns="60933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400"/>
              </a:pPr>
              <a:endParaRPr sz="1867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5" name="Google Shape;737;p10"/>
            <p:cNvSpPr/>
            <p:nvPr/>
          </p:nvSpPr>
          <p:spPr>
            <a:xfrm>
              <a:off x="5071728" y="3948597"/>
              <a:ext cx="507663" cy="462541"/>
            </a:xfrm>
            <a:custGeom>
              <a:avLst/>
              <a:gdLst/>
              <a:ahLst/>
              <a:cxnLst/>
              <a:rect l="l" t="t" r="r" b="b"/>
              <a:pathLst>
                <a:path w="382360" h="325957" extrusionOk="0">
                  <a:moveTo>
                    <a:pt x="97454" y="13832"/>
                  </a:moveTo>
                  <a:cubicBezTo>
                    <a:pt x="61228" y="38816"/>
                    <a:pt x="-1231" y="106272"/>
                    <a:pt x="18" y="156239"/>
                  </a:cubicBezTo>
                  <a:cubicBezTo>
                    <a:pt x="1267" y="206206"/>
                    <a:pt x="48736" y="291150"/>
                    <a:pt x="104949" y="313635"/>
                  </a:cubicBezTo>
                  <a:cubicBezTo>
                    <a:pt x="161162" y="336120"/>
                    <a:pt x="291077" y="327376"/>
                    <a:pt x="337297" y="291150"/>
                  </a:cubicBezTo>
                  <a:cubicBezTo>
                    <a:pt x="383517" y="254924"/>
                    <a:pt x="381018" y="139999"/>
                    <a:pt x="382267" y="96278"/>
                  </a:cubicBezTo>
                  <a:cubicBezTo>
                    <a:pt x="383516" y="52557"/>
                    <a:pt x="372274" y="43812"/>
                    <a:pt x="344792" y="28822"/>
                  </a:cubicBezTo>
                  <a:cubicBezTo>
                    <a:pt x="317310" y="13832"/>
                    <a:pt x="264845" y="7586"/>
                    <a:pt x="217376" y="6337"/>
                  </a:cubicBezTo>
                  <a:cubicBezTo>
                    <a:pt x="169907" y="5088"/>
                    <a:pt x="133680" y="-11152"/>
                    <a:pt x="97454" y="13832"/>
                  </a:cubicBezTo>
                  <a:close/>
                </a:path>
              </a:pathLst>
            </a:custGeom>
            <a:noFill/>
            <a:ln w="15875" cap="flat" cmpd="sng">
              <a:solidFill>
                <a:schemeClr val="lt1"/>
              </a:solidFill>
              <a:prstDash val="sysDot"/>
              <a:round/>
              <a:headEnd type="none" w="sm" len="sm"/>
              <a:tailEnd type="none" w="sm" len="sm"/>
            </a:ln>
          </p:spPr>
          <p:txBody>
            <a:bodyPr spcFirstLastPara="1" wrap="square" lIns="121900" tIns="60933" rIns="121900" bIns="60933" anchor="ctr" anchorCtr="0">
              <a:noAutofit/>
            </a:bodyPr>
            <a:lstStyle/>
            <a:p>
              <a:pPr algn="ctr">
                <a:buClr>
                  <a:srgbClr val="000000"/>
                </a:buClr>
                <a:buSzPts val="1400"/>
              </a:pPr>
              <a:endParaRPr sz="1867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6028659" y="988828"/>
              <a:ext cx="7124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7-GF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968406" y="2363972"/>
              <a:ext cx="140350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7-Ecto-tVSVG-GF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940053" y="3781646"/>
              <a:ext cx="140350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Transferrin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VSVG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986127" y="5305646"/>
              <a:ext cx="140350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NCAM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VSVG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3" name="Google Shape;803;p11"/>
          <p:cNvSpPr txBox="1"/>
          <p:nvPr/>
        </p:nvSpPr>
        <p:spPr>
          <a:xfrm>
            <a:off x="7921258" y="645687"/>
            <a:ext cx="3891514" cy="56630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just">
              <a:buClr>
                <a:srgbClr val="000000"/>
              </a:buClr>
              <a:buSzPts val="1400"/>
            </a:pP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igure </a:t>
            </a:r>
            <a:r>
              <a:rPr lang="en-US" sz="15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2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xpression and </a:t>
            </a:r>
            <a:r>
              <a:rPr lang="en-US" sz="15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-localization 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f genetic modifiers </a:t>
            </a:r>
            <a:r>
              <a:rPr lang="en-US" sz="1500" b="1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with exosome markers of CD63 and XPACK 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in cultured human 293T cells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Cells were co-transfected with either CD47-GFP and CD63-RFP (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, or CD47-Ecto-tVSVG-GFP and CD63-RFP (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, or </a:t>
            </a:r>
            <a:r>
              <a:rPr lang="en-US" sz="15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Transferrine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US" sz="15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VSVG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GFP and CD63-RFP (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, or NCAM-</a:t>
            </a:r>
            <a:r>
              <a:rPr lang="en-US" sz="15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VSVG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-GFP and XPACK-RFP (</a:t>
            </a:r>
            <a:r>
              <a:rPr lang="en-US" sz="15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. The confocal images were recorded after 24 </a:t>
            </a:r>
            <a:r>
              <a:rPr lang="en-US" sz="1500" dirty="0" err="1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rs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f transfection for green fluorescence signals 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column 1), red fluorescence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ignals (column 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), phase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TLI, 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lumn 3)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nd 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verlay (column 4), indicating co-localization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f either CD47-GFP, CD47-Ecto-tVSVG-GFP, </a:t>
            </a:r>
            <a:r>
              <a:rPr lang="en-US" sz="15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Transferrin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(green; pointed by white arrows) with exosome marker CD63 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green; white arrow) or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XPACK (red; white arrows). The convergence of red and green fluorescence signals is </a:t>
            </a:r>
            <a:r>
              <a:rPr lang="en-US" sz="1500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indicated 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y yellow signals in the overly images (right column). The margin of nucleus (</a:t>
            </a:r>
            <a:r>
              <a:rPr lang="en-US" sz="15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uc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 is marked by dotted lines. Scale bar: 10 </a:t>
            </a:r>
            <a:r>
              <a:rPr lang="en-US" sz="1500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μm</a:t>
            </a:r>
            <a:r>
              <a:rPr lang="en-US" sz="15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endParaRPr sz="15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29078" y="311782"/>
            <a:ext cx="554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1</a:t>
            </a:r>
            <a:endParaRPr lang="en-US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2665334" y="321018"/>
            <a:ext cx="531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2</a:t>
            </a:r>
            <a:endParaRPr lang="en-US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4193949" y="334871"/>
            <a:ext cx="531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3</a:t>
            </a:r>
            <a:endParaRPr lang="en-US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5764135" y="362580"/>
            <a:ext cx="531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4</a:t>
            </a:r>
            <a:endParaRPr lang="en-US" b="1" dirty="0"/>
          </a:p>
        </p:txBody>
      </p:sp>
      <p:grpSp>
        <p:nvGrpSpPr>
          <p:cNvPr id="21" name="Group 20"/>
          <p:cNvGrpSpPr/>
          <p:nvPr/>
        </p:nvGrpSpPr>
        <p:grpSpPr>
          <a:xfrm>
            <a:off x="76088" y="524218"/>
            <a:ext cx="6531214" cy="5823420"/>
            <a:chOff x="161152" y="524218"/>
            <a:chExt cx="6531214" cy="5823420"/>
          </a:xfrm>
        </p:grpSpPr>
        <p:grpSp>
          <p:nvGrpSpPr>
            <p:cNvPr id="8" name="Group 7"/>
            <p:cNvGrpSpPr/>
            <p:nvPr/>
          </p:nvGrpSpPr>
          <p:grpSpPr>
            <a:xfrm>
              <a:off x="161152" y="524218"/>
              <a:ext cx="6531214" cy="5823420"/>
              <a:chOff x="384436" y="471055"/>
              <a:chExt cx="6531214" cy="582342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384436" y="471055"/>
                <a:ext cx="6531214" cy="5792564"/>
                <a:chOff x="559927" y="919817"/>
                <a:chExt cx="6531214" cy="5417691"/>
              </a:xfrm>
            </p:grpSpPr>
            <p:pic>
              <p:nvPicPr>
                <p:cNvPr id="759" name="Google Shape;759;p11" descr="A picture containing green, dark, sitting, light&#10;&#10;Description automatically generated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/>
                <a:stretch/>
              </p:blipFill>
              <p:spPr>
                <a:xfrm>
                  <a:off x="1009835" y="1018774"/>
                  <a:ext cx="1475543" cy="125731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760" name="Google Shape;760;p11" descr="A picture containing dark, looking, light, lit&#10;&#10;Description automatically generated"/>
                <p:cNvPicPr preferRelativeResize="0"/>
                <p:nvPr/>
              </p:nvPicPr>
              <p:blipFill rotWithShape="1">
                <a:blip r:embed="rId4">
                  <a:alphaModFix/>
                </a:blip>
                <a:srcRect/>
                <a:stretch/>
              </p:blipFill>
              <p:spPr>
                <a:xfrm>
                  <a:off x="2528873" y="1026525"/>
                  <a:ext cx="1475543" cy="125731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761" name="Google Shape;761;p11"/>
                <p:cNvSpPr/>
                <p:nvPr/>
              </p:nvSpPr>
              <p:spPr>
                <a:xfrm>
                  <a:off x="1520215" y="2025426"/>
                  <a:ext cx="1167016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CD47-GFP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62" name="Google Shape;762;p11"/>
                <p:cNvSpPr/>
                <p:nvPr/>
              </p:nvSpPr>
              <p:spPr>
                <a:xfrm>
                  <a:off x="3036106" y="2033541"/>
                  <a:ext cx="1175980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CD63-RFP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63" name="Google Shape;763;p11"/>
                <p:cNvSpPr/>
                <p:nvPr/>
              </p:nvSpPr>
              <p:spPr>
                <a:xfrm>
                  <a:off x="1535932" y="1745652"/>
                  <a:ext cx="288421" cy="377947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374684" h="536604" extrusionOk="0">
                      <a:moveTo>
                        <a:pt x="196435" y="812"/>
                      </a:moveTo>
                      <a:cubicBezTo>
                        <a:pt x="161029" y="6970"/>
                        <a:pt x="94835" y="36218"/>
                        <a:pt x="67126" y="65466"/>
                      </a:cubicBezTo>
                      <a:cubicBezTo>
                        <a:pt x="39417" y="94714"/>
                        <a:pt x="39417" y="139357"/>
                        <a:pt x="30181" y="176302"/>
                      </a:cubicBezTo>
                      <a:cubicBezTo>
                        <a:pt x="20945" y="213247"/>
                        <a:pt x="16326" y="254812"/>
                        <a:pt x="11708" y="287139"/>
                      </a:cubicBezTo>
                      <a:cubicBezTo>
                        <a:pt x="7090" y="319466"/>
                        <a:pt x="-5225" y="337939"/>
                        <a:pt x="2472" y="370266"/>
                      </a:cubicBezTo>
                      <a:cubicBezTo>
                        <a:pt x="10169" y="402593"/>
                        <a:pt x="37878" y="453393"/>
                        <a:pt x="57890" y="481102"/>
                      </a:cubicBezTo>
                      <a:cubicBezTo>
                        <a:pt x="77902" y="508811"/>
                        <a:pt x="90217" y="534982"/>
                        <a:pt x="122544" y="536521"/>
                      </a:cubicBezTo>
                      <a:cubicBezTo>
                        <a:pt x="154871" y="538060"/>
                        <a:pt x="221065" y="518048"/>
                        <a:pt x="251853" y="490339"/>
                      </a:cubicBezTo>
                      <a:cubicBezTo>
                        <a:pt x="282641" y="462630"/>
                        <a:pt x="288799" y="401054"/>
                        <a:pt x="307272" y="370266"/>
                      </a:cubicBezTo>
                      <a:cubicBezTo>
                        <a:pt x="325745" y="339478"/>
                        <a:pt x="351914" y="345636"/>
                        <a:pt x="362690" y="305612"/>
                      </a:cubicBezTo>
                      <a:cubicBezTo>
                        <a:pt x="373466" y="265588"/>
                        <a:pt x="378084" y="173224"/>
                        <a:pt x="371926" y="130121"/>
                      </a:cubicBezTo>
                      <a:cubicBezTo>
                        <a:pt x="365768" y="87018"/>
                        <a:pt x="341138" y="63926"/>
                        <a:pt x="325744" y="46993"/>
                      </a:cubicBezTo>
                      <a:cubicBezTo>
                        <a:pt x="310350" y="30060"/>
                        <a:pt x="296495" y="31600"/>
                        <a:pt x="279562" y="28521"/>
                      </a:cubicBezTo>
                      <a:cubicBezTo>
                        <a:pt x="262629" y="25442"/>
                        <a:pt x="231841" y="-5346"/>
                        <a:pt x="196435" y="812"/>
                      </a:cubicBezTo>
                      <a:close/>
                    </a:path>
                  </a:pathLst>
                </a:custGeom>
                <a:noFill/>
                <a:ln w="9525" cap="flat" cmpd="sng">
                  <a:solidFill>
                    <a:schemeClr val="lt1"/>
                  </a:solidFill>
                  <a:prstDash val="dash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64" name="Google Shape;764;p11"/>
                <p:cNvSpPr/>
                <p:nvPr/>
              </p:nvSpPr>
              <p:spPr>
                <a:xfrm>
                  <a:off x="3037959" y="1777580"/>
                  <a:ext cx="261412" cy="348101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374684" h="536604" extrusionOk="0">
                      <a:moveTo>
                        <a:pt x="196435" y="812"/>
                      </a:moveTo>
                      <a:cubicBezTo>
                        <a:pt x="161029" y="6970"/>
                        <a:pt x="94835" y="36218"/>
                        <a:pt x="67126" y="65466"/>
                      </a:cubicBezTo>
                      <a:cubicBezTo>
                        <a:pt x="39417" y="94714"/>
                        <a:pt x="39417" y="139357"/>
                        <a:pt x="30181" y="176302"/>
                      </a:cubicBezTo>
                      <a:cubicBezTo>
                        <a:pt x="20945" y="213247"/>
                        <a:pt x="16326" y="254812"/>
                        <a:pt x="11708" y="287139"/>
                      </a:cubicBezTo>
                      <a:cubicBezTo>
                        <a:pt x="7090" y="319466"/>
                        <a:pt x="-5225" y="337939"/>
                        <a:pt x="2472" y="370266"/>
                      </a:cubicBezTo>
                      <a:cubicBezTo>
                        <a:pt x="10169" y="402593"/>
                        <a:pt x="37878" y="453393"/>
                        <a:pt x="57890" y="481102"/>
                      </a:cubicBezTo>
                      <a:cubicBezTo>
                        <a:pt x="77902" y="508811"/>
                        <a:pt x="90217" y="534982"/>
                        <a:pt x="122544" y="536521"/>
                      </a:cubicBezTo>
                      <a:cubicBezTo>
                        <a:pt x="154871" y="538060"/>
                        <a:pt x="221065" y="518048"/>
                        <a:pt x="251853" y="490339"/>
                      </a:cubicBezTo>
                      <a:cubicBezTo>
                        <a:pt x="282641" y="462630"/>
                        <a:pt x="288799" y="401054"/>
                        <a:pt x="307272" y="370266"/>
                      </a:cubicBezTo>
                      <a:cubicBezTo>
                        <a:pt x="325745" y="339478"/>
                        <a:pt x="351914" y="345636"/>
                        <a:pt x="362690" y="305612"/>
                      </a:cubicBezTo>
                      <a:cubicBezTo>
                        <a:pt x="373466" y="265588"/>
                        <a:pt x="378084" y="173224"/>
                        <a:pt x="371926" y="130121"/>
                      </a:cubicBezTo>
                      <a:cubicBezTo>
                        <a:pt x="365768" y="87018"/>
                        <a:pt x="341138" y="63926"/>
                        <a:pt x="325744" y="46993"/>
                      </a:cubicBezTo>
                      <a:cubicBezTo>
                        <a:pt x="310350" y="30060"/>
                        <a:pt x="296495" y="31600"/>
                        <a:pt x="279562" y="28521"/>
                      </a:cubicBezTo>
                      <a:cubicBezTo>
                        <a:pt x="262629" y="25442"/>
                        <a:pt x="231841" y="-5346"/>
                        <a:pt x="196435" y="812"/>
                      </a:cubicBezTo>
                      <a:close/>
                    </a:path>
                  </a:pathLst>
                </a:custGeom>
                <a:noFill/>
                <a:ln w="9525" cap="flat" cmpd="sng">
                  <a:solidFill>
                    <a:schemeClr val="lt1"/>
                  </a:solidFill>
                  <a:prstDash val="dash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765" name="Google Shape;765;p11"/>
                <p:cNvCxnSpPr/>
                <p:nvPr/>
              </p:nvCxnSpPr>
              <p:spPr>
                <a:xfrm>
                  <a:off x="1065641" y="1103729"/>
                  <a:ext cx="348383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</p:cxnSp>
            <p:sp>
              <p:nvSpPr>
                <p:cNvPr id="766" name="Google Shape;766;p11"/>
                <p:cNvSpPr txBox="1"/>
                <p:nvPr/>
              </p:nvSpPr>
              <p:spPr>
                <a:xfrm>
                  <a:off x="876765" y="1243114"/>
                  <a:ext cx="820932" cy="34882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100"/>
                  </a:pPr>
                  <a:r>
                    <a:rPr lang="en-US" sz="1467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10 μm</a:t>
                  </a:r>
                  <a:endParaRPr sz="1467" b="1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pic>
              <p:nvPicPr>
                <p:cNvPr id="767" name="Google Shape;767;p11" descr="A picture containing sitting, front, dark, green&#10;&#10;Description automatically generated"/>
                <p:cNvPicPr preferRelativeResize="0"/>
                <p:nvPr/>
              </p:nvPicPr>
              <p:blipFill rotWithShape="1">
                <a:blip r:embed="rId5">
                  <a:alphaModFix/>
                </a:blip>
                <a:srcRect l="40642" t="37706" r="28868" b="31806"/>
                <a:stretch/>
              </p:blipFill>
              <p:spPr>
                <a:xfrm>
                  <a:off x="1030854" y="2324058"/>
                  <a:ext cx="1471729" cy="125406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768" name="Google Shape;768;p11" descr="A star in the dark&#10;&#10;Description automatically generated"/>
                <p:cNvPicPr preferRelativeResize="0"/>
                <p:nvPr/>
              </p:nvPicPr>
              <p:blipFill rotWithShape="1">
                <a:blip r:embed="rId6">
                  <a:alphaModFix/>
                </a:blip>
                <a:srcRect l="39385" t="38052" r="30158" b="31490"/>
                <a:stretch/>
              </p:blipFill>
              <p:spPr>
                <a:xfrm>
                  <a:off x="2520293" y="2311587"/>
                  <a:ext cx="1471729" cy="125406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769" name="Google Shape;769;p11"/>
                <p:cNvSpPr/>
                <p:nvPr/>
              </p:nvSpPr>
              <p:spPr>
                <a:xfrm>
                  <a:off x="1513685" y="2670451"/>
                  <a:ext cx="487788" cy="430244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50172" h="584859" extrusionOk="0">
                      <a:moveTo>
                        <a:pt x="364032" y="10615"/>
                      </a:moveTo>
                      <a:cubicBezTo>
                        <a:pt x="328444" y="4335"/>
                        <a:pt x="292856" y="-1945"/>
                        <a:pt x="258524" y="567"/>
                      </a:cubicBezTo>
                      <a:cubicBezTo>
                        <a:pt x="224192" y="3079"/>
                        <a:pt x="192372" y="8103"/>
                        <a:pt x="158040" y="25688"/>
                      </a:cubicBezTo>
                      <a:cubicBezTo>
                        <a:pt x="123708" y="43273"/>
                        <a:pt x="78491" y="75093"/>
                        <a:pt x="52533" y="106075"/>
                      </a:cubicBezTo>
                      <a:cubicBezTo>
                        <a:pt x="26575" y="137057"/>
                        <a:pt x="8153" y="160503"/>
                        <a:pt x="2291" y="211582"/>
                      </a:cubicBezTo>
                      <a:cubicBezTo>
                        <a:pt x="-3571" y="262661"/>
                        <a:pt x="3965" y="362307"/>
                        <a:pt x="17363" y="412549"/>
                      </a:cubicBezTo>
                      <a:cubicBezTo>
                        <a:pt x="30761" y="462791"/>
                        <a:pt x="60069" y="488749"/>
                        <a:pt x="82678" y="513033"/>
                      </a:cubicBezTo>
                      <a:cubicBezTo>
                        <a:pt x="105287" y="537317"/>
                        <a:pt x="128732" y="546528"/>
                        <a:pt x="153016" y="558251"/>
                      </a:cubicBezTo>
                      <a:cubicBezTo>
                        <a:pt x="177299" y="569974"/>
                        <a:pt x="204933" y="580859"/>
                        <a:pt x="228379" y="583371"/>
                      </a:cubicBezTo>
                      <a:cubicBezTo>
                        <a:pt x="251825" y="585883"/>
                        <a:pt x="257687" y="586721"/>
                        <a:pt x="293693" y="573323"/>
                      </a:cubicBezTo>
                      <a:cubicBezTo>
                        <a:pt x="329699" y="559925"/>
                        <a:pt x="407574" y="533967"/>
                        <a:pt x="444418" y="502985"/>
                      </a:cubicBezTo>
                      <a:cubicBezTo>
                        <a:pt x="481262" y="472003"/>
                        <a:pt x="497172" y="424273"/>
                        <a:pt x="514757" y="387429"/>
                      </a:cubicBezTo>
                      <a:cubicBezTo>
                        <a:pt x="532342" y="350585"/>
                        <a:pt x="548251" y="320440"/>
                        <a:pt x="549926" y="281921"/>
                      </a:cubicBezTo>
                      <a:cubicBezTo>
                        <a:pt x="551601" y="243402"/>
                        <a:pt x="544902" y="198184"/>
                        <a:pt x="524805" y="156316"/>
                      </a:cubicBezTo>
                      <a:cubicBezTo>
                        <a:pt x="504708" y="114448"/>
                        <a:pt x="464515" y="55833"/>
                        <a:pt x="429346" y="30712"/>
                      </a:cubicBezTo>
                      <a:cubicBezTo>
                        <a:pt x="394177" y="5591"/>
                        <a:pt x="340586" y="8941"/>
                        <a:pt x="313790" y="5591"/>
                      </a:cubicBezTo>
                      <a:cubicBezTo>
                        <a:pt x="286994" y="2241"/>
                        <a:pt x="282807" y="9778"/>
                        <a:pt x="268572" y="10615"/>
                      </a:cubicBezTo>
                      <a:cubicBezTo>
                        <a:pt x="254337" y="11452"/>
                        <a:pt x="247638" y="8103"/>
                        <a:pt x="228379" y="10615"/>
                      </a:cubicBezTo>
                      <a:cubicBezTo>
                        <a:pt x="209120" y="13127"/>
                        <a:pt x="178137" y="15640"/>
                        <a:pt x="153016" y="25688"/>
                      </a:cubicBezTo>
                      <a:cubicBezTo>
                        <a:pt x="127895" y="35736"/>
                        <a:pt x="98587" y="53320"/>
                        <a:pt x="77653" y="70905"/>
                      </a:cubicBezTo>
                      <a:cubicBezTo>
                        <a:pt x="56719" y="88490"/>
                        <a:pt x="39972" y="102726"/>
                        <a:pt x="27412" y="131196"/>
                      </a:cubicBezTo>
                      <a:cubicBezTo>
                        <a:pt x="14852" y="159666"/>
                        <a:pt x="6478" y="212419"/>
                        <a:pt x="2291" y="241727"/>
                      </a:cubicBezTo>
                      <a:cubicBezTo>
                        <a:pt x="-1896" y="271035"/>
                        <a:pt x="616" y="286945"/>
                        <a:pt x="2291" y="307042"/>
                      </a:cubicBezTo>
                      <a:cubicBezTo>
                        <a:pt x="3966" y="327139"/>
                        <a:pt x="8152" y="344723"/>
                        <a:pt x="12339" y="362308"/>
                      </a:cubicBezTo>
                    </a:path>
                  </a:pathLst>
                </a:custGeom>
                <a:noFill/>
                <a:ln w="9525" cap="flat" cmpd="sng">
                  <a:solidFill>
                    <a:schemeClr val="lt1"/>
                  </a:solidFill>
                  <a:prstDash val="dash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70" name="Google Shape;770;p11"/>
                <p:cNvSpPr/>
                <p:nvPr/>
              </p:nvSpPr>
              <p:spPr>
                <a:xfrm>
                  <a:off x="903378" y="3136902"/>
                  <a:ext cx="1796477" cy="53329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 algn="ctr">
                    <a:buClr>
                      <a:srgbClr val="000000"/>
                    </a:buClr>
                    <a:buSzPts val="1000"/>
                  </a:pPr>
                  <a:r>
                    <a:rPr lang="en-US"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CD47-Ecto-tVSVG-GFP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71" name="Google Shape;771;p11"/>
                <p:cNvSpPr/>
                <p:nvPr/>
              </p:nvSpPr>
              <p:spPr>
                <a:xfrm>
                  <a:off x="3018155" y="3282489"/>
                  <a:ext cx="1144917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CD63-RFP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772" name="Google Shape;772;p11"/>
                <p:cNvCxnSpPr/>
                <p:nvPr/>
              </p:nvCxnSpPr>
              <p:spPr>
                <a:xfrm flipH="1">
                  <a:off x="1684196" y="1412745"/>
                  <a:ext cx="82763" cy="138808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73" name="Google Shape;773;p11"/>
                <p:cNvCxnSpPr/>
                <p:nvPr/>
              </p:nvCxnSpPr>
              <p:spPr>
                <a:xfrm>
                  <a:off x="2847379" y="1825521"/>
                  <a:ext cx="95317" cy="53672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774" name="Google Shape;774;p11"/>
                <p:cNvCxnSpPr/>
                <p:nvPr/>
              </p:nvCxnSpPr>
              <p:spPr>
                <a:xfrm>
                  <a:off x="2809858" y="1969399"/>
                  <a:ext cx="95317" cy="53672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775" name="Google Shape;775;p11"/>
                <p:cNvCxnSpPr/>
                <p:nvPr/>
              </p:nvCxnSpPr>
              <p:spPr>
                <a:xfrm flipH="1">
                  <a:off x="1787385" y="1452711"/>
                  <a:ext cx="82761" cy="138808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76" name="Google Shape;776;p11"/>
                <p:cNvCxnSpPr/>
                <p:nvPr/>
              </p:nvCxnSpPr>
              <p:spPr>
                <a:xfrm flipH="1">
                  <a:off x="1577148" y="2526572"/>
                  <a:ext cx="105387" cy="109656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77" name="Google Shape;777;p11"/>
                <p:cNvCxnSpPr/>
                <p:nvPr/>
              </p:nvCxnSpPr>
              <p:spPr>
                <a:xfrm rot="10800000">
                  <a:off x="3996539" y="3136935"/>
                  <a:ext cx="619" cy="2023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778" name="Google Shape;778;p11"/>
                <p:cNvCxnSpPr/>
                <p:nvPr/>
              </p:nvCxnSpPr>
              <p:spPr>
                <a:xfrm>
                  <a:off x="1355871" y="1817528"/>
                  <a:ext cx="95317" cy="53672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779" name="Google Shape;779;p11"/>
                <p:cNvCxnSpPr/>
                <p:nvPr/>
              </p:nvCxnSpPr>
              <p:spPr>
                <a:xfrm>
                  <a:off x="1308968" y="1985385"/>
                  <a:ext cx="95317" cy="53672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pic>
              <p:nvPicPr>
                <p:cNvPr id="780" name="Google Shape;780;p11" descr="A picture containing animal, group, standing, old&#10;&#10;Description automatically generated"/>
                <p:cNvPicPr preferRelativeResize="0"/>
                <p:nvPr/>
              </p:nvPicPr>
              <p:blipFill rotWithShape="1">
                <a:blip r:embed="rId7">
                  <a:alphaModFix/>
                </a:blip>
                <a:srcRect/>
                <a:stretch/>
              </p:blipFill>
              <p:spPr>
                <a:xfrm>
                  <a:off x="4043225" y="1026373"/>
                  <a:ext cx="1475543" cy="125731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781" name="Google Shape;781;p11" descr="A picture containing animal, cake, bird, man&#10;&#10;Description automatically generated"/>
                <p:cNvPicPr preferRelativeResize="0"/>
                <p:nvPr/>
              </p:nvPicPr>
              <p:blipFill rotWithShape="1">
                <a:blip r:embed="rId8">
                  <a:alphaModFix/>
                </a:blip>
                <a:srcRect/>
                <a:stretch/>
              </p:blipFill>
              <p:spPr>
                <a:xfrm>
                  <a:off x="5595574" y="1051237"/>
                  <a:ext cx="1475543" cy="125731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782" name="Google Shape;782;p11"/>
                <p:cNvSpPr/>
                <p:nvPr/>
              </p:nvSpPr>
              <p:spPr>
                <a:xfrm>
                  <a:off x="4510381" y="1973255"/>
                  <a:ext cx="582231" cy="3692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200"/>
                  </a:pPr>
                  <a:r>
                    <a:rPr lang="en-US" sz="1600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TLI</a:t>
                  </a:r>
                  <a:endParaRPr sz="1600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83" name="Google Shape;783;p11"/>
                <p:cNvSpPr/>
                <p:nvPr/>
              </p:nvSpPr>
              <p:spPr>
                <a:xfrm>
                  <a:off x="5871293" y="2036242"/>
                  <a:ext cx="1063799" cy="3692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200"/>
                  </a:pPr>
                  <a:r>
                    <a:rPr lang="en-US" sz="1600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Overlay</a:t>
                  </a:r>
                  <a:endParaRPr sz="1600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pic>
              <p:nvPicPr>
                <p:cNvPr id="784" name="Google Shape;784;p11" descr="A picture containing nature, rain, table, white&#10;&#10;Description automatically generated"/>
                <p:cNvPicPr preferRelativeResize="0"/>
                <p:nvPr/>
              </p:nvPicPr>
              <p:blipFill rotWithShape="1">
                <a:blip r:embed="rId9">
                  <a:alphaModFix/>
                </a:blip>
                <a:srcRect l="40218" t="37008" r="29622" b="34164"/>
                <a:stretch/>
              </p:blipFill>
              <p:spPr>
                <a:xfrm>
                  <a:off x="4050847" y="2318188"/>
                  <a:ext cx="1469916" cy="1250933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785" name="Google Shape;785;p11" descr="A picture containing rain&#10;&#10;Description automatically generated"/>
                <p:cNvPicPr preferRelativeResize="0"/>
                <p:nvPr/>
              </p:nvPicPr>
              <p:blipFill rotWithShape="1">
                <a:blip r:embed="rId10">
                  <a:alphaModFix/>
                </a:blip>
                <a:srcRect l="41115" t="36541" r="28429" b="33003"/>
                <a:stretch/>
              </p:blipFill>
              <p:spPr>
                <a:xfrm>
                  <a:off x="5600834" y="2319963"/>
                  <a:ext cx="1471729" cy="125406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786" name="Google Shape;786;p11"/>
                <p:cNvSpPr/>
                <p:nvPr/>
              </p:nvSpPr>
              <p:spPr>
                <a:xfrm>
                  <a:off x="4598957" y="3264595"/>
                  <a:ext cx="716065" cy="3692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200"/>
                  </a:pPr>
                  <a:r>
                    <a:rPr lang="en-US" sz="1600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TLI</a:t>
                  </a:r>
                  <a:endParaRPr sz="1600" b="1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787" name="Google Shape;787;p11"/>
                <p:cNvSpPr/>
                <p:nvPr/>
              </p:nvSpPr>
              <p:spPr>
                <a:xfrm>
                  <a:off x="5949901" y="3237085"/>
                  <a:ext cx="1101241" cy="3692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200"/>
                  </a:pPr>
                  <a:r>
                    <a:rPr lang="en-US" sz="1600" b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Overlay</a:t>
                  </a:r>
                  <a:endParaRPr sz="1600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788" name="Google Shape;788;p11"/>
                <p:cNvCxnSpPr/>
                <p:nvPr/>
              </p:nvCxnSpPr>
              <p:spPr>
                <a:xfrm>
                  <a:off x="5914822" y="1801543"/>
                  <a:ext cx="95317" cy="53672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chemeClr val="bg1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789" name="Google Shape;789;p11"/>
                <p:cNvCxnSpPr/>
                <p:nvPr/>
              </p:nvCxnSpPr>
              <p:spPr>
                <a:xfrm>
                  <a:off x="5867919" y="1985385"/>
                  <a:ext cx="95317" cy="53672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chemeClr val="bg1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sp>
              <p:nvSpPr>
                <p:cNvPr id="790" name="Google Shape;790;p11"/>
                <p:cNvSpPr/>
                <p:nvPr/>
              </p:nvSpPr>
              <p:spPr>
                <a:xfrm>
                  <a:off x="3080238" y="2646471"/>
                  <a:ext cx="487788" cy="430244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550172" h="584859" extrusionOk="0">
                      <a:moveTo>
                        <a:pt x="364032" y="10615"/>
                      </a:moveTo>
                      <a:cubicBezTo>
                        <a:pt x="328444" y="4335"/>
                        <a:pt x="292856" y="-1945"/>
                        <a:pt x="258524" y="567"/>
                      </a:cubicBezTo>
                      <a:cubicBezTo>
                        <a:pt x="224192" y="3079"/>
                        <a:pt x="192372" y="8103"/>
                        <a:pt x="158040" y="25688"/>
                      </a:cubicBezTo>
                      <a:cubicBezTo>
                        <a:pt x="123708" y="43273"/>
                        <a:pt x="78491" y="75093"/>
                        <a:pt x="52533" y="106075"/>
                      </a:cubicBezTo>
                      <a:cubicBezTo>
                        <a:pt x="26575" y="137057"/>
                        <a:pt x="8153" y="160503"/>
                        <a:pt x="2291" y="211582"/>
                      </a:cubicBezTo>
                      <a:cubicBezTo>
                        <a:pt x="-3571" y="262661"/>
                        <a:pt x="3965" y="362307"/>
                        <a:pt x="17363" y="412549"/>
                      </a:cubicBezTo>
                      <a:cubicBezTo>
                        <a:pt x="30761" y="462791"/>
                        <a:pt x="60069" y="488749"/>
                        <a:pt x="82678" y="513033"/>
                      </a:cubicBezTo>
                      <a:cubicBezTo>
                        <a:pt x="105287" y="537317"/>
                        <a:pt x="128732" y="546528"/>
                        <a:pt x="153016" y="558251"/>
                      </a:cubicBezTo>
                      <a:cubicBezTo>
                        <a:pt x="177299" y="569974"/>
                        <a:pt x="204933" y="580859"/>
                        <a:pt x="228379" y="583371"/>
                      </a:cubicBezTo>
                      <a:cubicBezTo>
                        <a:pt x="251825" y="585883"/>
                        <a:pt x="257687" y="586721"/>
                        <a:pt x="293693" y="573323"/>
                      </a:cubicBezTo>
                      <a:cubicBezTo>
                        <a:pt x="329699" y="559925"/>
                        <a:pt x="407574" y="533967"/>
                        <a:pt x="444418" y="502985"/>
                      </a:cubicBezTo>
                      <a:cubicBezTo>
                        <a:pt x="481262" y="472003"/>
                        <a:pt x="497172" y="424273"/>
                        <a:pt x="514757" y="387429"/>
                      </a:cubicBezTo>
                      <a:cubicBezTo>
                        <a:pt x="532342" y="350585"/>
                        <a:pt x="548251" y="320440"/>
                        <a:pt x="549926" y="281921"/>
                      </a:cubicBezTo>
                      <a:cubicBezTo>
                        <a:pt x="551601" y="243402"/>
                        <a:pt x="544902" y="198184"/>
                        <a:pt x="524805" y="156316"/>
                      </a:cubicBezTo>
                      <a:cubicBezTo>
                        <a:pt x="504708" y="114448"/>
                        <a:pt x="464515" y="55833"/>
                        <a:pt x="429346" y="30712"/>
                      </a:cubicBezTo>
                      <a:cubicBezTo>
                        <a:pt x="394177" y="5591"/>
                        <a:pt x="340586" y="8941"/>
                        <a:pt x="313790" y="5591"/>
                      </a:cubicBezTo>
                      <a:cubicBezTo>
                        <a:pt x="286994" y="2241"/>
                        <a:pt x="282807" y="9778"/>
                        <a:pt x="268572" y="10615"/>
                      </a:cubicBezTo>
                      <a:cubicBezTo>
                        <a:pt x="254337" y="11452"/>
                        <a:pt x="247638" y="8103"/>
                        <a:pt x="228379" y="10615"/>
                      </a:cubicBezTo>
                      <a:cubicBezTo>
                        <a:pt x="209120" y="13127"/>
                        <a:pt x="178137" y="15640"/>
                        <a:pt x="153016" y="25688"/>
                      </a:cubicBezTo>
                      <a:cubicBezTo>
                        <a:pt x="127895" y="35736"/>
                        <a:pt x="98587" y="53320"/>
                        <a:pt x="77653" y="70905"/>
                      </a:cubicBezTo>
                      <a:cubicBezTo>
                        <a:pt x="56719" y="88490"/>
                        <a:pt x="39972" y="102726"/>
                        <a:pt x="27412" y="131196"/>
                      </a:cubicBezTo>
                      <a:cubicBezTo>
                        <a:pt x="14852" y="159666"/>
                        <a:pt x="6478" y="212419"/>
                        <a:pt x="2291" y="241727"/>
                      </a:cubicBezTo>
                      <a:cubicBezTo>
                        <a:pt x="-1896" y="271035"/>
                        <a:pt x="616" y="286945"/>
                        <a:pt x="2291" y="307042"/>
                      </a:cubicBezTo>
                      <a:cubicBezTo>
                        <a:pt x="3966" y="327139"/>
                        <a:pt x="8152" y="344723"/>
                        <a:pt x="12339" y="362308"/>
                      </a:cubicBezTo>
                    </a:path>
                  </a:pathLst>
                </a:custGeom>
                <a:noFill/>
                <a:ln w="9525" cap="flat" cmpd="sng">
                  <a:solidFill>
                    <a:schemeClr val="lt1"/>
                  </a:solidFill>
                  <a:prstDash val="dash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121900" tIns="60933" rIns="121900" bIns="60933" anchor="ctr" anchorCtr="0">
                  <a:noAutofit/>
                </a:bodyPr>
                <a:lstStyle/>
                <a:p>
                  <a:pPr algn="ctr">
                    <a:buClr>
                      <a:srgbClr val="000000"/>
                    </a:buClr>
                    <a:buSzPts val="1400"/>
                  </a:pPr>
                  <a:endParaRPr sz="1867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791" name="Google Shape;791;p11"/>
                <p:cNvCxnSpPr/>
                <p:nvPr/>
              </p:nvCxnSpPr>
              <p:spPr>
                <a:xfrm flipH="1">
                  <a:off x="3231988" y="1423509"/>
                  <a:ext cx="82763" cy="138808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2" name="Google Shape;792;p11"/>
                <p:cNvCxnSpPr/>
                <p:nvPr/>
              </p:nvCxnSpPr>
              <p:spPr>
                <a:xfrm flipH="1">
                  <a:off x="3335177" y="1463475"/>
                  <a:ext cx="82761" cy="138808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3" name="Google Shape;793;p11"/>
                <p:cNvCxnSpPr/>
                <p:nvPr/>
              </p:nvCxnSpPr>
              <p:spPr>
                <a:xfrm flipH="1">
                  <a:off x="6261909" y="1447489"/>
                  <a:ext cx="82763" cy="138808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bg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4" name="Google Shape;794;p11"/>
                <p:cNvCxnSpPr/>
                <p:nvPr/>
              </p:nvCxnSpPr>
              <p:spPr>
                <a:xfrm flipH="1">
                  <a:off x="6365097" y="1487455"/>
                  <a:ext cx="82761" cy="138808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bg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5" name="Google Shape;795;p11"/>
                <p:cNvCxnSpPr/>
                <p:nvPr/>
              </p:nvCxnSpPr>
              <p:spPr>
                <a:xfrm flipH="1">
                  <a:off x="2168123" y="2790348"/>
                  <a:ext cx="105387" cy="109656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6" name="Google Shape;796;p11"/>
                <p:cNvCxnSpPr/>
                <p:nvPr/>
              </p:nvCxnSpPr>
              <p:spPr>
                <a:xfrm flipH="1">
                  <a:off x="3134321" y="2510587"/>
                  <a:ext cx="105387" cy="109656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7" name="Google Shape;797;p11"/>
                <p:cNvCxnSpPr/>
                <p:nvPr/>
              </p:nvCxnSpPr>
              <p:spPr>
                <a:xfrm flipH="1">
                  <a:off x="3725296" y="2774363"/>
                  <a:ext cx="105387" cy="109656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lt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cxnSp>
              <p:nvCxnSpPr>
                <p:cNvPr id="798" name="Google Shape;798;p11"/>
                <p:cNvCxnSpPr/>
                <p:nvPr/>
              </p:nvCxnSpPr>
              <p:spPr>
                <a:xfrm rot="10800000">
                  <a:off x="3705742" y="3033025"/>
                  <a:ext cx="190604" cy="45081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799" name="Google Shape;799;p11"/>
                <p:cNvCxnSpPr/>
                <p:nvPr/>
              </p:nvCxnSpPr>
              <p:spPr>
                <a:xfrm rot="10800000">
                  <a:off x="2176710" y="3041017"/>
                  <a:ext cx="190604" cy="45081"/>
                </a:xfrm>
                <a:prstGeom prst="straightConnector1">
                  <a:avLst/>
                </a:prstGeom>
                <a:noFill/>
                <a:ln w="44450" cap="flat" cmpd="sng">
                  <a:solidFill>
                    <a:srgbClr val="D8D8D8"/>
                  </a:solidFill>
                  <a:prstDash val="dot"/>
                  <a:round/>
                  <a:headEnd type="none" w="sm" len="sm"/>
                  <a:tailEnd type="stealth" w="med" len="med"/>
                </a:ln>
              </p:spPr>
            </p:cxnSp>
            <p:cxnSp>
              <p:nvCxnSpPr>
                <p:cNvPr id="800" name="Google Shape;800;p11"/>
                <p:cNvCxnSpPr/>
                <p:nvPr/>
              </p:nvCxnSpPr>
              <p:spPr>
                <a:xfrm flipH="1">
                  <a:off x="6098576" y="2566539"/>
                  <a:ext cx="105387" cy="109656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triangle" w="med" len="med"/>
                </a:ln>
              </p:spPr>
            </p:cxnSp>
            <p:sp>
              <p:nvSpPr>
                <p:cNvPr id="801" name="Google Shape;801;p11"/>
                <p:cNvSpPr txBox="1"/>
                <p:nvPr/>
              </p:nvSpPr>
              <p:spPr>
                <a:xfrm>
                  <a:off x="1412075" y="1792247"/>
                  <a:ext cx="924252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Nuc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02" name="Google Shape;802;p11"/>
                <p:cNvSpPr txBox="1"/>
                <p:nvPr/>
              </p:nvSpPr>
              <p:spPr>
                <a:xfrm>
                  <a:off x="1506387" y="2742954"/>
                  <a:ext cx="924252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 dirty="0" err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Nuc</a:t>
                  </a:r>
                  <a:endParaRPr sz="1333" dirty="0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pic>
              <p:nvPicPr>
                <p:cNvPr id="804" name="Google Shape;804;p11"/>
                <p:cNvPicPr preferRelativeResize="0"/>
                <p:nvPr/>
              </p:nvPicPr>
              <p:blipFill rotWithShape="1">
                <a:blip r:embed="rId11">
                  <a:alphaModFix/>
                </a:blip>
                <a:srcRect/>
                <a:stretch/>
              </p:blipFill>
              <p:spPr>
                <a:xfrm>
                  <a:off x="1043969" y="3664647"/>
                  <a:ext cx="6047172" cy="2672861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805" name="Google Shape;805;p11"/>
                <p:cNvSpPr txBox="1"/>
                <p:nvPr/>
              </p:nvSpPr>
              <p:spPr>
                <a:xfrm>
                  <a:off x="1178852" y="3682757"/>
                  <a:ext cx="1335802" cy="498784"/>
                </a:xfrm>
                <a:prstGeom prst="rect">
                  <a:avLst/>
                </a:prstGeom>
                <a:solidFill>
                  <a:schemeClr val="dk1"/>
                </a:solidFill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 dirty="0" err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hTransferrin</a:t>
                  </a:r>
                  <a:r>
                    <a:rPr lang="en-US" sz="1333" dirty="0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r>
                    <a:rPr lang="en-US" sz="1333" dirty="0" err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tVSVG</a:t>
                  </a:r>
                  <a:r>
                    <a:rPr lang="en-US" sz="1333" dirty="0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GFP</a:t>
                  </a:r>
                  <a:endParaRPr sz="1333" dirty="0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06" name="Google Shape;806;p11"/>
                <p:cNvSpPr txBox="1"/>
                <p:nvPr/>
              </p:nvSpPr>
              <p:spPr>
                <a:xfrm>
                  <a:off x="1127416" y="5048320"/>
                  <a:ext cx="1418492" cy="533297"/>
                </a:xfrm>
                <a:prstGeom prst="rect">
                  <a:avLst/>
                </a:prstGeom>
                <a:solidFill>
                  <a:schemeClr val="dk1"/>
                </a:solidFill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 dirty="0" err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hTransferrin</a:t>
                  </a:r>
                  <a:r>
                    <a:rPr lang="en-US" sz="1333" dirty="0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</a:t>
                  </a:r>
                  <a:r>
                    <a:rPr lang="en-US" sz="1333" dirty="0" err="1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tVSVG</a:t>
                  </a:r>
                  <a:r>
                    <a:rPr lang="en-US" sz="1333" dirty="0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-GFP</a:t>
                  </a:r>
                  <a:endParaRPr sz="1333" dirty="0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07" name="Google Shape;807;p11"/>
                <p:cNvSpPr txBox="1"/>
                <p:nvPr/>
              </p:nvSpPr>
              <p:spPr>
                <a:xfrm>
                  <a:off x="4845175" y="5024526"/>
                  <a:ext cx="375140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I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08" name="Google Shape;808;p11"/>
                <p:cNvSpPr txBox="1"/>
                <p:nvPr/>
              </p:nvSpPr>
              <p:spPr>
                <a:xfrm>
                  <a:off x="4825637" y="3680281"/>
                  <a:ext cx="375140" cy="3281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000"/>
                  </a:pPr>
                  <a:r>
                    <a:rPr lang="en-US" sz="1333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I</a:t>
                  </a:r>
                  <a:endParaRPr sz="1333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09" name="Google Shape;809;p11"/>
                <p:cNvSpPr/>
                <p:nvPr/>
              </p:nvSpPr>
              <p:spPr>
                <a:xfrm>
                  <a:off x="606327" y="919817"/>
                  <a:ext cx="419347" cy="41037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400"/>
                  </a:pPr>
                  <a:r>
                    <a:rPr lang="en-US" sz="1867" b="1" dirty="0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A</a:t>
                  </a:r>
                  <a:endParaRPr sz="1867" dirty="0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10" name="Google Shape;810;p11"/>
                <p:cNvSpPr/>
                <p:nvPr/>
              </p:nvSpPr>
              <p:spPr>
                <a:xfrm>
                  <a:off x="559927" y="2246217"/>
                  <a:ext cx="419347" cy="41037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400"/>
                  </a:pPr>
                  <a:r>
                    <a:rPr lang="en-US" sz="1867" b="1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B</a:t>
                  </a:r>
                  <a:endParaRPr sz="1867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11" name="Google Shape;811;p11"/>
                <p:cNvSpPr/>
                <p:nvPr/>
              </p:nvSpPr>
              <p:spPr>
                <a:xfrm>
                  <a:off x="588727" y="3551817"/>
                  <a:ext cx="419347" cy="41037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400"/>
                  </a:pPr>
                  <a:r>
                    <a:rPr lang="en-US" sz="1867" b="1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C</a:t>
                  </a:r>
                  <a:endParaRPr sz="1867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812" name="Google Shape;812;p11"/>
                <p:cNvSpPr/>
                <p:nvPr/>
              </p:nvSpPr>
              <p:spPr>
                <a:xfrm>
                  <a:off x="599927" y="4926217"/>
                  <a:ext cx="419347" cy="41037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121900" tIns="60933" rIns="121900" bIns="60933" anchor="t" anchorCtr="0">
                  <a:spAutoFit/>
                </a:bodyPr>
                <a:lstStyle/>
                <a:p>
                  <a:pPr>
                    <a:buClr>
                      <a:srgbClr val="000000"/>
                    </a:buClr>
                    <a:buSzPts val="1400"/>
                  </a:pPr>
                  <a:r>
                    <a:rPr lang="en-US" sz="1867" b="1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D</a:t>
                  </a:r>
                  <a:endParaRPr sz="1867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cxnSp>
            <p:nvCxnSpPr>
              <p:cNvPr id="6" name="Straight Connector 5"/>
              <p:cNvCxnSpPr/>
              <p:nvPr/>
            </p:nvCxnSpPr>
            <p:spPr>
              <a:xfrm>
                <a:off x="2339162" y="3423684"/>
                <a:ext cx="0" cy="2870791"/>
              </a:xfrm>
              <a:prstGeom prst="line">
                <a:avLst/>
              </a:prstGeom>
              <a:ln w="41275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/>
              <p:cNvCxnSpPr/>
              <p:nvPr/>
            </p:nvCxnSpPr>
            <p:spPr>
              <a:xfrm>
                <a:off x="3873795" y="3405963"/>
                <a:ext cx="0" cy="2870791"/>
              </a:xfrm>
              <a:prstGeom prst="line">
                <a:avLst/>
              </a:prstGeom>
              <a:ln w="4445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>
                <a:off x="5387162" y="3388242"/>
                <a:ext cx="0" cy="2870791"/>
              </a:xfrm>
              <a:prstGeom prst="line">
                <a:avLst/>
              </a:prstGeom>
              <a:ln w="4445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 flipH="1">
                <a:off x="861237" y="4813450"/>
                <a:ext cx="6033148" cy="24366"/>
              </a:xfrm>
              <a:prstGeom prst="line">
                <a:avLst/>
              </a:prstGeom>
              <a:ln w="50800"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0" name="Google Shape;765;p11"/>
            <p:cNvCxnSpPr/>
            <p:nvPr/>
          </p:nvCxnSpPr>
          <p:spPr>
            <a:xfrm>
              <a:off x="712941" y="3531395"/>
              <a:ext cx="348383" cy="0"/>
            </a:xfrm>
            <a:prstGeom prst="straightConnector1">
              <a:avLst/>
            </a:prstGeom>
            <a:noFill/>
            <a:ln w="28575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71" name="Google Shape;765;p11"/>
            <p:cNvCxnSpPr/>
            <p:nvPr/>
          </p:nvCxnSpPr>
          <p:spPr>
            <a:xfrm>
              <a:off x="737750" y="5002232"/>
              <a:ext cx="348383" cy="0"/>
            </a:xfrm>
            <a:prstGeom prst="straightConnector1">
              <a:avLst/>
            </a:prstGeom>
            <a:noFill/>
            <a:ln w="28575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72" name="Google Shape;792;p11"/>
            <p:cNvCxnSpPr/>
            <p:nvPr/>
          </p:nvCxnSpPr>
          <p:spPr>
            <a:xfrm flipV="1">
              <a:off x="1297172" y="4412512"/>
              <a:ext cx="308344" cy="148858"/>
            </a:xfrm>
            <a:prstGeom prst="straightConnector1">
              <a:avLst/>
            </a:prstGeom>
            <a:noFill/>
            <a:ln w="34925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75" name="Google Shape;792;p11"/>
            <p:cNvCxnSpPr/>
            <p:nvPr/>
          </p:nvCxnSpPr>
          <p:spPr>
            <a:xfrm flipV="1">
              <a:off x="2775098" y="4391246"/>
              <a:ext cx="329609" cy="148857"/>
            </a:xfrm>
            <a:prstGeom prst="straightConnector1">
              <a:avLst/>
            </a:prstGeom>
            <a:noFill/>
            <a:ln w="31750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81" name="Google Shape;792;p11"/>
            <p:cNvCxnSpPr/>
            <p:nvPr/>
          </p:nvCxnSpPr>
          <p:spPr>
            <a:xfrm flipV="1">
              <a:off x="5819554" y="4405423"/>
              <a:ext cx="329609" cy="148857"/>
            </a:xfrm>
            <a:prstGeom prst="straightConnector1">
              <a:avLst/>
            </a:prstGeom>
            <a:noFill/>
            <a:ln w="31750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82" name="Google Shape;792;p11"/>
            <p:cNvCxnSpPr/>
            <p:nvPr/>
          </p:nvCxnSpPr>
          <p:spPr>
            <a:xfrm flipH="1">
              <a:off x="985284" y="5688419"/>
              <a:ext cx="311888" cy="166577"/>
            </a:xfrm>
            <a:prstGeom prst="straightConnector1">
              <a:avLst/>
            </a:prstGeom>
            <a:noFill/>
            <a:ln w="31750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84" name="Google Shape;792;p11"/>
            <p:cNvCxnSpPr/>
            <p:nvPr/>
          </p:nvCxnSpPr>
          <p:spPr>
            <a:xfrm flipH="1">
              <a:off x="2541182" y="5677786"/>
              <a:ext cx="340241" cy="180754"/>
            </a:xfrm>
            <a:prstGeom prst="straightConnector1">
              <a:avLst/>
            </a:prstGeom>
            <a:noFill/>
            <a:ln w="31750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cxnSp>
          <p:nvCxnSpPr>
            <p:cNvPr id="87" name="Google Shape;792;p11"/>
            <p:cNvCxnSpPr/>
            <p:nvPr/>
          </p:nvCxnSpPr>
          <p:spPr>
            <a:xfrm flipH="1">
              <a:off x="5468679" y="5713228"/>
              <a:ext cx="340241" cy="180754"/>
            </a:xfrm>
            <a:prstGeom prst="straightConnector1">
              <a:avLst/>
            </a:prstGeom>
            <a:noFill/>
            <a:ln w="31750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19" name="Freeform 18"/>
            <p:cNvSpPr/>
            <p:nvPr/>
          </p:nvSpPr>
          <p:spPr>
            <a:xfrm>
              <a:off x="1700062" y="4307333"/>
              <a:ext cx="332642" cy="232770"/>
            </a:xfrm>
            <a:custGeom>
              <a:avLst/>
              <a:gdLst>
                <a:gd name="connsiteX0" fmla="*/ 277594 w 332642"/>
                <a:gd name="connsiteY0" fmla="*/ 9486 h 232770"/>
                <a:gd name="connsiteX1" fmla="*/ 54310 w 332642"/>
                <a:gd name="connsiteY1" fmla="*/ 9486 h 232770"/>
                <a:gd name="connsiteX2" fmla="*/ 1147 w 332642"/>
                <a:gd name="connsiteY2" fmla="*/ 105179 h 232770"/>
                <a:gd name="connsiteX3" fmla="*/ 86208 w 332642"/>
                <a:gd name="connsiteY3" fmla="*/ 190239 h 232770"/>
                <a:gd name="connsiteX4" fmla="*/ 245696 w 332642"/>
                <a:gd name="connsiteY4" fmla="*/ 232770 h 232770"/>
                <a:gd name="connsiteX5" fmla="*/ 309492 w 332642"/>
                <a:gd name="connsiteY5" fmla="*/ 190239 h 232770"/>
                <a:gd name="connsiteX6" fmla="*/ 330757 w 332642"/>
                <a:gd name="connsiteY6" fmla="*/ 62649 h 232770"/>
                <a:gd name="connsiteX7" fmla="*/ 277594 w 332642"/>
                <a:gd name="connsiteY7" fmla="*/ 9486 h 232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2642" h="232770">
                  <a:moveTo>
                    <a:pt x="277594" y="9486"/>
                  </a:moveTo>
                  <a:cubicBezTo>
                    <a:pt x="231519" y="625"/>
                    <a:pt x="100384" y="-6463"/>
                    <a:pt x="54310" y="9486"/>
                  </a:cubicBezTo>
                  <a:cubicBezTo>
                    <a:pt x="8235" y="25435"/>
                    <a:pt x="-4169" y="75054"/>
                    <a:pt x="1147" y="105179"/>
                  </a:cubicBezTo>
                  <a:cubicBezTo>
                    <a:pt x="6463" y="135304"/>
                    <a:pt x="45450" y="168974"/>
                    <a:pt x="86208" y="190239"/>
                  </a:cubicBezTo>
                  <a:cubicBezTo>
                    <a:pt x="126966" y="211504"/>
                    <a:pt x="208482" y="232770"/>
                    <a:pt x="245696" y="232770"/>
                  </a:cubicBezTo>
                  <a:cubicBezTo>
                    <a:pt x="282910" y="232770"/>
                    <a:pt x="295315" y="218592"/>
                    <a:pt x="309492" y="190239"/>
                  </a:cubicBezTo>
                  <a:cubicBezTo>
                    <a:pt x="323669" y="161886"/>
                    <a:pt x="337845" y="96319"/>
                    <a:pt x="330757" y="62649"/>
                  </a:cubicBezTo>
                  <a:cubicBezTo>
                    <a:pt x="323669" y="28979"/>
                    <a:pt x="323669" y="18347"/>
                    <a:pt x="277594" y="9486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9" name="Google Shape;792;p11"/>
            <p:cNvCxnSpPr/>
            <p:nvPr/>
          </p:nvCxnSpPr>
          <p:spPr>
            <a:xfrm flipH="1">
              <a:off x="2693582" y="5830186"/>
              <a:ext cx="340241" cy="180754"/>
            </a:xfrm>
            <a:prstGeom prst="straightConnector1">
              <a:avLst/>
            </a:prstGeom>
            <a:noFill/>
            <a:ln w="31750" cap="flat" cmpd="sng">
              <a:solidFill>
                <a:schemeClr val="lt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90" name="Freeform 89"/>
            <p:cNvSpPr/>
            <p:nvPr/>
          </p:nvSpPr>
          <p:spPr>
            <a:xfrm>
              <a:off x="3181532" y="4310877"/>
              <a:ext cx="332642" cy="232770"/>
            </a:xfrm>
            <a:custGeom>
              <a:avLst/>
              <a:gdLst>
                <a:gd name="connsiteX0" fmla="*/ 277594 w 332642"/>
                <a:gd name="connsiteY0" fmla="*/ 9486 h 232770"/>
                <a:gd name="connsiteX1" fmla="*/ 54310 w 332642"/>
                <a:gd name="connsiteY1" fmla="*/ 9486 h 232770"/>
                <a:gd name="connsiteX2" fmla="*/ 1147 w 332642"/>
                <a:gd name="connsiteY2" fmla="*/ 105179 h 232770"/>
                <a:gd name="connsiteX3" fmla="*/ 86208 w 332642"/>
                <a:gd name="connsiteY3" fmla="*/ 190239 h 232770"/>
                <a:gd name="connsiteX4" fmla="*/ 245696 w 332642"/>
                <a:gd name="connsiteY4" fmla="*/ 232770 h 232770"/>
                <a:gd name="connsiteX5" fmla="*/ 309492 w 332642"/>
                <a:gd name="connsiteY5" fmla="*/ 190239 h 232770"/>
                <a:gd name="connsiteX6" fmla="*/ 330757 w 332642"/>
                <a:gd name="connsiteY6" fmla="*/ 62649 h 232770"/>
                <a:gd name="connsiteX7" fmla="*/ 277594 w 332642"/>
                <a:gd name="connsiteY7" fmla="*/ 9486 h 232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2642" h="232770">
                  <a:moveTo>
                    <a:pt x="277594" y="9486"/>
                  </a:moveTo>
                  <a:cubicBezTo>
                    <a:pt x="231519" y="625"/>
                    <a:pt x="100384" y="-6463"/>
                    <a:pt x="54310" y="9486"/>
                  </a:cubicBezTo>
                  <a:cubicBezTo>
                    <a:pt x="8235" y="25435"/>
                    <a:pt x="-4169" y="75054"/>
                    <a:pt x="1147" y="105179"/>
                  </a:cubicBezTo>
                  <a:cubicBezTo>
                    <a:pt x="6463" y="135304"/>
                    <a:pt x="45450" y="168974"/>
                    <a:pt x="86208" y="190239"/>
                  </a:cubicBezTo>
                  <a:cubicBezTo>
                    <a:pt x="126966" y="211504"/>
                    <a:pt x="208482" y="232770"/>
                    <a:pt x="245696" y="232770"/>
                  </a:cubicBezTo>
                  <a:cubicBezTo>
                    <a:pt x="282910" y="232770"/>
                    <a:pt x="295315" y="218592"/>
                    <a:pt x="309492" y="190239"/>
                  </a:cubicBezTo>
                  <a:cubicBezTo>
                    <a:pt x="323669" y="161886"/>
                    <a:pt x="337845" y="96319"/>
                    <a:pt x="330757" y="62649"/>
                  </a:cubicBezTo>
                  <a:cubicBezTo>
                    <a:pt x="323669" y="28979"/>
                    <a:pt x="323669" y="18347"/>
                    <a:pt x="277594" y="9486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1" name="Freeform 90"/>
            <p:cNvSpPr/>
            <p:nvPr/>
          </p:nvSpPr>
          <p:spPr>
            <a:xfrm>
              <a:off x="6201178" y="4289612"/>
              <a:ext cx="332642" cy="232770"/>
            </a:xfrm>
            <a:custGeom>
              <a:avLst/>
              <a:gdLst>
                <a:gd name="connsiteX0" fmla="*/ 277594 w 332642"/>
                <a:gd name="connsiteY0" fmla="*/ 9486 h 232770"/>
                <a:gd name="connsiteX1" fmla="*/ 54310 w 332642"/>
                <a:gd name="connsiteY1" fmla="*/ 9486 h 232770"/>
                <a:gd name="connsiteX2" fmla="*/ 1147 w 332642"/>
                <a:gd name="connsiteY2" fmla="*/ 105179 h 232770"/>
                <a:gd name="connsiteX3" fmla="*/ 86208 w 332642"/>
                <a:gd name="connsiteY3" fmla="*/ 190239 h 232770"/>
                <a:gd name="connsiteX4" fmla="*/ 245696 w 332642"/>
                <a:gd name="connsiteY4" fmla="*/ 232770 h 232770"/>
                <a:gd name="connsiteX5" fmla="*/ 309492 w 332642"/>
                <a:gd name="connsiteY5" fmla="*/ 190239 h 232770"/>
                <a:gd name="connsiteX6" fmla="*/ 330757 w 332642"/>
                <a:gd name="connsiteY6" fmla="*/ 62649 h 232770"/>
                <a:gd name="connsiteX7" fmla="*/ 277594 w 332642"/>
                <a:gd name="connsiteY7" fmla="*/ 9486 h 232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2642" h="232770">
                  <a:moveTo>
                    <a:pt x="277594" y="9486"/>
                  </a:moveTo>
                  <a:cubicBezTo>
                    <a:pt x="231519" y="625"/>
                    <a:pt x="100384" y="-6463"/>
                    <a:pt x="54310" y="9486"/>
                  </a:cubicBezTo>
                  <a:cubicBezTo>
                    <a:pt x="8235" y="25435"/>
                    <a:pt x="-4169" y="75054"/>
                    <a:pt x="1147" y="105179"/>
                  </a:cubicBezTo>
                  <a:cubicBezTo>
                    <a:pt x="6463" y="135304"/>
                    <a:pt x="45450" y="168974"/>
                    <a:pt x="86208" y="190239"/>
                  </a:cubicBezTo>
                  <a:cubicBezTo>
                    <a:pt x="126966" y="211504"/>
                    <a:pt x="208482" y="232770"/>
                    <a:pt x="245696" y="232770"/>
                  </a:cubicBezTo>
                  <a:cubicBezTo>
                    <a:pt x="282910" y="232770"/>
                    <a:pt x="295315" y="218592"/>
                    <a:pt x="309492" y="190239"/>
                  </a:cubicBezTo>
                  <a:cubicBezTo>
                    <a:pt x="323669" y="161886"/>
                    <a:pt x="337845" y="96319"/>
                    <a:pt x="330757" y="62649"/>
                  </a:cubicBezTo>
                  <a:cubicBezTo>
                    <a:pt x="323669" y="28979"/>
                    <a:pt x="323669" y="18347"/>
                    <a:pt x="277594" y="9486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2" name="Freeform 91"/>
            <p:cNvSpPr/>
            <p:nvPr/>
          </p:nvSpPr>
          <p:spPr>
            <a:xfrm>
              <a:off x="4744518" y="4321509"/>
              <a:ext cx="332642" cy="232770"/>
            </a:xfrm>
            <a:custGeom>
              <a:avLst/>
              <a:gdLst>
                <a:gd name="connsiteX0" fmla="*/ 277594 w 332642"/>
                <a:gd name="connsiteY0" fmla="*/ 9486 h 232770"/>
                <a:gd name="connsiteX1" fmla="*/ 54310 w 332642"/>
                <a:gd name="connsiteY1" fmla="*/ 9486 h 232770"/>
                <a:gd name="connsiteX2" fmla="*/ 1147 w 332642"/>
                <a:gd name="connsiteY2" fmla="*/ 105179 h 232770"/>
                <a:gd name="connsiteX3" fmla="*/ 86208 w 332642"/>
                <a:gd name="connsiteY3" fmla="*/ 190239 h 232770"/>
                <a:gd name="connsiteX4" fmla="*/ 245696 w 332642"/>
                <a:gd name="connsiteY4" fmla="*/ 232770 h 232770"/>
                <a:gd name="connsiteX5" fmla="*/ 309492 w 332642"/>
                <a:gd name="connsiteY5" fmla="*/ 190239 h 232770"/>
                <a:gd name="connsiteX6" fmla="*/ 330757 w 332642"/>
                <a:gd name="connsiteY6" fmla="*/ 62649 h 232770"/>
                <a:gd name="connsiteX7" fmla="*/ 277594 w 332642"/>
                <a:gd name="connsiteY7" fmla="*/ 9486 h 2327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2642" h="232770">
                  <a:moveTo>
                    <a:pt x="277594" y="9486"/>
                  </a:moveTo>
                  <a:cubicBezTo>
                    <a:pt x="231519" y="625"/>
                    <a:pt x="100384" y="-6463"/>
                    <a:pt x="54310" y="9486"/>
                  </a:cubicBezTo>
                  <a:cubicBezTo>
                    <a:pt x="8235" y="25435"/>
                    <a:pt x="-4169" y="75054"/>
                    <a:pt x="1147" y="105179"/>
                  </a:cubicBezTo>
                  <a:cubicBezTo>
                    <a:pt x="6463" y="135304"/>
                    <a:pt x="45450" y="168974"/>
                    <a:pt x="86208" y="190239"/>
                  </a:cubicBezTo>
                  <a:cubicBezTo>
                    <a:pt x="126966" y="211504"/>
                    <a:pt x="208482" y="232770"/>
                    <a:pt x="245696" y="232770"/>
                  </a:cubicBezTo>
                  <a:cubicBezTo>
                    <a:pt x="282910" y="232770"/>
                    <a:pt x="295315" y="218592"/>
                    <a:pt x="309492" y="190239"/>
                  </a:cubicBezTo>
                  <a:cubicBezTo>
                    <a:pt x="323669" y="161886"/>
                    <a:pt x="337845" y="96319"/>
                    <a:pt x="330757" y="62649"/>
                  </a:cubicBezTo>
                  <a:cubicBezTo>
                    <a:pt x="323669" y="28979"/>
                    <a:pt x="323669" y="18347"/>
                    <a:pt x="277594" y="9486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Freeform 19"/>
            <p:cNvSpPr/>
            <p:nvPr/>
          </p:nvSpPr>
          <p:spPr>
            <a:xfrm>
              <a:off x="1658329" y="5938204"/>
              <a:ext cx="381212" cy="231468"/>
            </a:xfrm>
            <a:custGeom>
              <a:avLst/>
              <a:gdLst>
                <a:gd name="connsiteX0" fmla="*/ 372490 w 381212"/>
                <a:gd name="connsiteY0" fmla="*/ 132987 h 231468"/>
                <a:gd name="connsiteX1" fmla="*/ 191736 w 381212"/>
                <a:gd name="connsiteY1" fmla="*/ 218047 h 231468"/>
                <a:gd name="connsiteX2" fmla="*/ 64145 w 381212"/>
                <a:gd name="connsiteY2" fmla="*/ 218047 h 231468"/>
                <a:gd name="connsiteX3" fmla="*/ 10983 w 381212"/>
                <a:gd name="connsiteY3" fmla="*/ 90457 h 231468"/>
                <a:gd name="connsiteX4" fmla="*/ 10983 w 381212"/>
                <a:gd name="connsiteY4" fmla="*/ 37294 h 231468"/>
                <a:gd name="connsiteX5" fmla="*/ 127941 w 381212"/>
                <a:gd name="connsiteY5" fmla="*/ 5396 h 231468"/>
                <a:gd name="connsiteX6" fmla="*/ 234266 w 381212"/>
                <a:gd name="connsiteY6" fmla="*/ 5396 h 231468"/>
                <a:gd name="connsiteX7" fmla="*/ 340592 w 381212"/>
                <a:gd name="connsiteY7" fmla="*/ 58559 h 231468"/>
                <a:gd name="connsiteX8" fmla="*/ 372490 w 381212"/>
                <a:gd name="connsiteY8" fmla="*/ 132987 h 2314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81212" h="231468">
                  <a:moveTo>
                    <a:pt x="372490" y="132987"/>
                  </a:moveTo>
                  <a:cubicBezTo>
                    <a:pt x="347681" y="159568"/>
                    <a:pt x="243127" y="203870"/>
                    <a:pt x="191736" y="218047"/>
                  </a:cubicBezTo>
                  <a:cubicBezTo>
                    <a:pt x="140345" y="232224"/>
                    <a:pt x="94270" y="239312"/>
                    <a:pt x="64145" y="218047"/>
                  </a:cubicBezTo>
                  <a:cubicBezTo>
                    <a:pt x="34020" y="196782"/>
                    <a:pt x="19843" y="120583"/>
                    <a:pt x="10983" y="90457"/>
                  </a:cubicBezTo>
                  <a:cubicBezTo>
                    <a:pt x="2123" y="60331"/>
                    <a:pt x="-8510" y="51471"/>
                    <a:pt x="10983" y="37294"/>
                  </a:cubicBezTo>
                  <a:cubicBezTo>
                    <a:pt x="30476" y="23117"/>
                    <a:pt x="90727" y="10712"/>
                    <a:pt x="127941" y="5396"/>
                  </a:cubicBezTo>
                  <a:cubicBezTo>
                    <a:pt x="165155" y="80"/>
                    <a:pt x="198824" y="-3464"/>
                    <a:pt x="234266" y="5396"/>
                  </a:cubicBezTo>
                  <a:cubicBezTo>
                    <a:pt x="269708" y="14256"/>
                    <a:pt x="317555" y="39066"/>
                    <a:pt x="340592" y="58559"/>
                  </a:cubicBezTo>
                  <a:cubicBezTo>
                    <a:pt x="363629" y="78052"/>
                    <a:pt x="397299" y="106406"/>
                    <a:pt x="372490" y="132987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Freeform 93"/>
            <p:cNvSpPr/>
            <p:nvPr/>
          </p:nvSpPr>
          <p:spPr>
            <a:xfrm>
              <a:off x="4681520" y="5984278"/>
              <a:ext cx="381212" cy="231468"/>
            </a:xfrm>
            <a:custGeom>
              <a:avLst/>
              <a:gdLst>
                <a:gd name="connsiteX0" fmla="*/ 372490 w 381212"/>
                <a:gd name="connsiteY0" fmla="*/ 132987 h 231468"/>
                <a:gd name="connsiteX1" fmla="*/ 191736 w 381212"/>
                <a:gd name="connsiteY1" fmla="*/ 218047 h 231468"/>
                <a:gd name="connsiteX2" fmla="*/ 64145 w 381212"/>
                <a:gd name="connsiteY2" fmla="*/ 218047 h 231468"/>
                <a:gd name="connsiteX3" fmla="*/ 10983 w 381212"/>
                <a:gd name="connsiteY3" fmla="*/ 90457 h 231468"/>
                <a:gd name="connsiteX4" fmla="*/ 10983 w 381212"/>
                <a:gd name="connsiteY4" fmla="*/ 37294 h 231468"/>
                <a:gd name="connsiteX5" fmla="*/ 127941 w 381212"/>
                <a:gd name="connsiteY5" fmla="*/ 5396 h 231468"/>
                <a:gd name="connsiteX6" fmla="*/ 234266 w 381212"/>
                <a:gd name="connsiteY6" fmla="*/ 5396 h 231468"/>
                <a:gd name="connsiteX7" fmla="*/ 340592 w 381212"/>
                <a:gd name="connsiteY7" fmla="*/ 58559 h 231468"/>
                <a:gd name="connsiteX8" fmla="*/ 372490 w 381212"/>
                <a:gd name="connsiteY8" fmla="*/ 132987 h 2314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81212" h="231468">
                  <a:moveTo>
                    <a:pt x="372490" y="132987"/>
                  </a:moveTo>
                  <a:cubicBezTo>
                    <a:pt x="347681" y="159568"/>
                    <a:pt x="243127" y="203870"/>
                    <a:pt x="191736" y="218047"/>
                  </a:cubicBezTo>
                  <a:cubicBezTo>
                    <a:pt x="140345" y="232224"/>
                    <a:pt x="94270" y="239312"/>
                    <a:pt x="64145" y="218047"/>
                  </a:cubicBezTo>
                  <a:cubicBezTo>
                    <a:pt x="34020" y="196782"/>
                    <a:pt x="19843" y="120583"/>
                    <a:pt x="10983" y="90457"/>
                  </a:cubicBezTo>
                  <a:cubicBezTo>
                    <a:pt x="2123" y="60331"/>
                    <a:pt x="-8510" y="51471"/>
                    <a:pt x="10983" y="37294"/>
                  </a:cubicBezTo>
                  <a:cubicBezTo>
                    <a:pt x="30476" y="23117"/>
                    <a:pt x="90727" y="10712"/>
                    <a:pt x="127941" y="5396"/>
                  </a:cubicBezTo>
                  <a:cubicBezTo>
                    <a:pt x="165155" y="80"/>
                    <a:pt x="198824" y="-3464"/>
                    <a:pt x="234266" y="5396"/>
                  </a:cubicBezTo>
                  <a:cubicBezTo>
                    <a:pt x="269708" y="14256"/>
                    <a:pt x="317555" y="39066"/>
                    <a:pt x="340592" y="58559"/>
                  </a:cubicBezTo>
                  <a:cubicBezTo>
                    <a:pt x="363629" y="78052"/>
                    <a:pt x="397299" y="106406"/>
                    <a:pt x="372490" y="132987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Freeform 94"/>
            <p:cNvSpPr/>
            <p:nvPr/>
          </p:nvSpPr>
          <p:spPr>
            <a:xfrm>
              <a:off x="3122078" y="5955925"/>
              <a:ext cx="381212" cy="231468"/>
            </a:xfrm>
            <a:custGeom>
              <a:avLst/>
              <a:gdLst>
                <a:gd name="connsiteX0" fmla="*/ 372490 w 381212"/>
                <a:gd name="connsiteY0" fmla="*/ 132987 h 231468"/>
                <a:gd name="connsiteX1" fmla="*/ 191736 w 381212"/>
                <a:gd name="connsiteY1" fmla="*/ 218047 h 231468"/>
                <a:gd name="connsiteX2" fmla="*/ 64145 w 381212"/>
                <a:gd name="connsiteY2" fmla="*/ 218047 h 231468"/>
                <a:gd name="connsiteX3" fmla="*/ 10983 w 381212"/>
                <a:gd name="connsiteY3" fmla="*/ 90457 h 231468"/>
                <a:gd name="connsiteX4" fmla="*/ 10983 w 381212"/>
                <a:gd name="connsiteY4" fmla="*/ 37294 h 231468"/>
                <a:gd name="connsiteX5" fmla="*/ 127941 w 381212"/>
                <a:gd name="connsiteY5" fmla="*/ 5396 h 231468"/>
                <a:gd name="connsiteX6" fmla="*/ 234266 w 381212"/>
                <a:gd name="connsiteY6" fmla="*/ 5396 h 231468"/>
                <a:gd name="connsiteX7" fmla="*/ 340592 w 381212"/>
                <a:gd name="connsiteY7" fmla="*/ 58559 h 231468"/>
                <a:gd name="connsiteX8" fmla="*/ 372490 w 381212"/>
                <a:gd name="connsiteY8" fmla="*/ 132987 h 2314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81212" h="231468">
                  <a:moveTo>
                    <a:pt x="372490" y="132987"/>
                  </a:moveTo>
                  <a:cubicBezTo>
                    <a:pt x="347681" y="159568"/>
                    <a:pt x="243127" y="203870"/>
                    <a:pt x="191736" y="218047"/>
                  </a:cubicBezTo>
                  <a:cubicBezTo>
                    <a:pt x="140345" y="232224"/>
                    <a:pt x="94270" y="239312"/>
                    <a:pt x="64145" y="218047"/>
                  </a:cubicBezTo>
                  <a:cubicBezTo>
                    <a:pt x="34020" y="196782"/>
                    <a:pt x="19843" y="120583"/>
                    <a:pt x="10983" y="90457"/>
                  </a:cubicBezTo>
                  <a:cubicBezTo>
                    <a:pt x="2123" y="60331"/>
                    <a:pt x="-8510" y="51471"/>
                    <a:pt x="10983" y="37294"/>
                  </a:cubicBezTo>
                  <a:cubicBezTo>
                    <a:pt x="30476" y="23117"/>
                    <a:pt x="90727" y="10712"/>
                    <a:pt x="127941" y="5396"/>
                  </a:cubicBezTo>
                  <a:cubicBezTo>
                    <a:pt x="165155" y="80"/>
                    <a:pt x="198824" y="-3464"/>
                    <a:pt x="234266" y="5396"/>
                  </a:cubicBezTo>
                  <a:cubicBezTo>
                    <a:pt x="269708" y="14256"/>
                    <a:pt x="317555" y="39066"/>
                    <a:pt x="340592" y="58559"/>
                  </a:cubicBezTo>
                  <a:cubicBezTo>
                    <a:pt x="363629" y="78052"/>
                    <a:pt x="397299" y="106406"/>
                    <a:pt x="372490" y="132987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Freeform 95"/>
            <p:cNvSpPr/>
            <p:nvPr/>
          </p:nvSpPr>
          <p:spPr>
            <a:xfrm>
              <a:off x="6184255" y="5966558"/>
              <a:ext cx="381212" cy="231468"/>
            </a:xfrm>
            <a:custGeom>
              <a:avLst/>
              <a:gdLst>
                <a:gd name="connsiteX0" fmla="*/ 372490 w 381212"/>
                <a:gd name="connsiteY0" fmla="*/ 132987 h 231468"/>
                <a:gd name="connsiteX1" fmla="*/ 191736 w 381212"/>
                <a:gd name="connsiteY1" fmla="*/ 218047 h 231468"/>
                <a:gd name="connsiteX2" fmla="*/ 64145 w 381212"/>
                <a:gd name="connsiteY2" fmla="*/ 218047 h 231468"/>
                <a:gd name="connsiteX3" fmla="*/ 10983 w 381212"/>
                <a:gd name="connsiteY3" fmla="*/ 90457 h 231468"/>
                <a:gd name="connsiteX4" fmla="*/ 10983 w 381212"/>
                <a:gd name="connsiteY4" fmla="*/ 37294 h 231468"/>
                <a:gd name="connsiteX5" fmla="*/ 127941 w 381212"/>
                <a:gd name="connsiteY5" fmla="*/ 5396 h 231468"/>
                <a:gd name="connsiteX6" fmla="*/ 234266 w 381212"/>
                <a:gd name="connsiteY6" fmla="*/ 5396 h 231468"/>
                <a:gd name="connsiteX7" fmla="*/ 340592 w 381212"/>
                <a:gd name="connsiteY7" fmla="*/ 58559 h 231468"/>
                <a:gd name="connsiteX8" fmla="*/ 372490 w 381212"/>
                <a:gd name="connsiteY8" fmla="*/ 132987 h 2314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381212" h="231468">
                  <a:moveTo>
                    <a:pt x="372490" y="132987"/>
                  </a:moveTo>
                  <a:cubicBezTo>
                    <a:pt x="347681" y="159568"/>
                    <a:pt x="243127" y="203870"/>
                    <a:pt x="191736" y="218047"/>
                  </a:cubicBezTo>
                  <a:cubicBezTo>
                    <a:pt x="140345" y="232224"/>
                    <a:pt x="94270" y="239312"/>
                    <a:pt x="64145" y="218047"/>
                  </a:cubicBezTo>
                  <a:cubicBezTo>
                    <a:pt x="34020" y="196782"/>
                    <a:pt x="19843" y="120583"/>
                    <a:pt x="10983" y="90457"/>
                  </a:cubicBezTo>
                  <a:cubicBezTo>
                    <a:pt x="2123" y="60331"/>
                    <a:pt x="-8510" y="51471"/>
                    <a:pt x="10983" y="37294"/>
                  </a:cubicBezTo>
                  <a:cubicBezTo>
                    <a:pt x="30476" y="23117"/>
                    <a:pt x="90727" y="10712"/>
                    <a:pt x="127941" y="5396"/>
                  </a:cubicBezTo>
                  <a:cubicBezTo>
                    <a:pt x="165155" y="80"/>
                    <a:pt x="198824" y="-3464"/>
                    <a:pt x="234266" y="5396"/>
                  </a:cubicBezTo>
                  <a:cubicBezTo>
                    <a:pt x="269708" y="14256"/>
                    <a:pt x="317555" y="39066"/>
                    <a:pt x="340592" y="58559"/>
                  </a:cubicBezTo>
                  <a:cubicBezTo>
                    <a:pt x="363629" y="78052"/>
                    <a:pt x="397299" y="106406"/>
                    <a:pt x="372490" y="132987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Google Shape;802;p11"/>
            <p:cNvSpPr txBox="1"/>
            <p:nvPr/>
          </p:nvSpPr>
          <p:spPr>
            <a:xfrm>
              <a:off x="1578989" y="4231422"/>
              <a:ext cx="924252" cy="3508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000"/>
              </a:pPr>
              <a:r>
                <a:rPr lang="en-US" sz="1333" dirty="0" err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Nuc</a:t>
              </a:r>
              <a:endParaRPr sz="1333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8" name="Google Shape;802;p11"/>
            <p:cNvSpPr txBox="1"/>
            <p:nvPr/>
          </p:nvSpPr>
          <p:spPr>
            <a:xfrm>
              <a:off x="1578989" y="5879468"/>
              <a:ext cx="924252" cy="3508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60933" rIns="121900" bIns="60933" anchor="t" anchorCtr="0">
              <a:spAutoFit/>
            </a:bodyPr>
            <a:lstStyle/>
            <a:p>
              <a:pPr>
                <a:buClr>
                  <a:srgbClr val="000000"/>
                </a:buClr>
                <a:buSzPts val="1000"/>
              </a:pPr>
              <a:r>
                <a:rPr lang="en-US" sz="1333" dirty="0" err="1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rPr>
                <a:t>Nuc</a:t>
              </a:r>
              <a:endParaRPr sz="1333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6475222" y="1041991"/>
            <a:ext cx="119084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7-GFP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63-RFP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6436235" y="2236382"/>
            <a:ext cx="144248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7-Ecto-tVSVG-GFP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63-RFP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6482310" y="3664689"/>
            <a:ext cx="152400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Transferrin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VSV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63-RFP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496487" y="5146159"/>
            <a:ext cx="152400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Transferrin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VSV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PACK-RFP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7" name="Google Shape;817;p1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583083" y="1008186"/>
            <a:ext cx="2820752" cy="1652953"/>
          </a:xfrm>
          <a:prstGeom prst="rect">
            <a:avLst/>
          </a:prstGeom>
          <a:noFill/>
          <a:ln>
            <a:noFill/>
          </a:ln>
        </p:spPr>
      </p:pic>
      <p:sp>
        <p:nvSpPr>
          <p:cNvPr id="818" name="Google Shape;818;p12"/>
          <p:cNvSpPr/>
          <p:nvPr/>
        </p:nvSpPr>
        <p:spPr>
          <a:xfrm>
            <a:off x="8346916" y="1730936"/>
            <a:ext cx="1626941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ode: 82 +/- 0.7 nm</a:t>
            </a:r>
            <a:endParaRPr sz="12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19" name="Google Shape;819;p12"/>
          <p:cNvSpPr/>
          <p:nvPr/>
        </p:nvSpPr>
        <p:spPr>
          <a:xfrm>
            <a:off x="7144210" y="689924"/>
            <a:ext cx="908796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.05E+08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20" name="Google Shape;820;p12"/>
          <p:cNvSpPr txBox="1"/>
          <p:nvPr/>
        </p:nvSpPr>
        <p:spPr>
          <a:xfrm>
            <a:off x="8237345" y="1375789"/>
            <a:ext cx="1878227" cy="3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200"/>
            </a:pPr>
            <a:r>
              <a:rPr lang="en-US" sz="1600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trol exosome</a:t>
            </a:r>
            <a:endParaRPr sz="1867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21" name="Google Shape;821;p12"/>
          <p:cNvSpPr/>
          <p:nvPr/>
        </p:nvSpPr>
        <p:spPr>
          <a:xfrm>
            <a:off x="544127" y="3421403"/>
            <a:ext cx="908796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.23E+09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22" name="Google Shape;822;p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184257" y="3744723"/>
            <a:ext cx="2906153" cy="1730591"/>
          </a:xfrm>
          <a:prstGeom prst="rect">
            <a:avLst/>
          </a:prstGeom>
          <a:noFill/>
          <a:ln>
            <a:noFill/>
          </a:ln>
        </p:spPr>
      </p:pic>
      <p:sp>
        <p:nvSpPr>
          <p:cNvPr id="823" name="Google Shape;823;p12"/>
          <p:cNvSpPr/>
          <p:nvPr/>
        </p:nvSpPr>
        <p:spPr>
          <a:xfrm>
            <a:off x="1955995" y="4580401"/>
            <a:ext cx="1626941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ode: 72 +/- 2.9 nm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24" name="Google Shape;824;p12"/>
          <p:cNvSpPr txBox="1"/>
          <p:nvPr/>
        </p:nvSpPr>
        <p:spPr>
          <a:xfrm>
            <a:off x="1569947" y="4067277"/>
            <a:ext cx="2357284" cy="5539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50"/>
            </a:pPr>
            <a:r>
              <a:rPr lang="en-US" sz="14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Transferrin-tVSVG-GFP exosome</a:t>
            </a:r>
            <a:endParaRPr sz="1867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25" name="Google Shape;825;p12"/>
          <p:cNvSpPr/>
          <p:nvPr/>
        </p:nvSpPr>
        <p:spPr>
          <a:xfrm>
            <a:off x="4029677" y="3446115"/>
            <a:ext cx="908796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.16E+09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26" name="Google Shape;826;p12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442643" y="3722573"/>
            <a:ext cx="2777824" cy="1728659"/>
          </a:xfrm>
          <a:prstGeom prst="rect">
            <a:avLst/>
          </a:prstGeom>
          <a:noFill/>
          <a:ln>
            <a:noFill/>
          </a:ln>
        </p:spPr>
      </p:pic>
      <p:sp>
        <p:nvSpPr>
          <p:cNvPr id="827" name="Google Shape;827;p12"/>
          <p:cNvSpPr/>
          <p:nvPr/>
        </p:nvSpPr>
        <p:spPr>
          <a:xfrm>
            <a:off x="5237049" y="4539761"/>
            <a:ext cx="1845276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ode: 85 +/- 6.4 nm</a:t>
            </a:r>
            <a:endParaRPr sz="1867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28" name="Google Shape;828;p12"/>
          <p:cNvSpPr/>
          <p:nvPr/>
        </p:nvSpPr>
        <p:spPr>
          <a:xfrm>
            <a:off x="5028192" y="4043090"/>
            <a:ext cx="1982529" cy="5539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50"/>
            </a:pPr>
            <a:r>
              <a:rPr lang="en-US" sz="14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NCAM-tVSVG-GFP exosome</a:t>
            </a:r>
            <a:endParaRPr sz="1867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29" name="Google Shape;829;p12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1117683" y="842488"/>
            <a:ext cx="2787719" cy="1832275"/>
          </a:xfrm>
          <a:prstGeom prst="rect">
            <a:avLst/>
          </a:prstGeom>
          <a:noFill/>
          <a:ln>
            <a:noFill/>
          </a:ln>
        </p:spPr>
      </p:pic>
      <p:sp>
        <p:nvSpPr>
          <p:cNvPr id="830" name="Google Shape;830;p12"/>
          <p:cNvSpPr/>
          <p:nvPr/>
        </p:nvSpPr>
        <p:spPr>
          <a:xfrm>
            <a:off x="1903394" y="1707613"/>
            <a:ext cx="1626941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ode: 60 +/- 0.7 nm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1" name="Google Shape;831;p12"/>
          <p:cNvSpPr/>
          <p:nvPr/>
        </p:nvSpPr>
        <p:spPr>
          <a:xfrm>
            <a:off x="568199" y="605960"/>
            <a:ext cx="1022076" cy="338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050"/>
            </a:pPr>
            <a:r>
              <a:rPr lang="en-US" sz="14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.48E+09</a:t>
            </a:r>
            <a:endParaRPr sz="1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32" name="Google Shape;832;p12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320002" y="890955"/>
            <a:ext cx="2749013" cy="1735016"/>
          </a:xfrm>
          <a:prstGeom prst="rect">
            <a:avLst/>
          </a:prstGeom>
          <a:noFill/>
          <a:ln>
            <a:noFill/>
          </a:ln>
        </p:spPr>
      </p:pic>
      <p:sp>
        <p:nvSpPr>
          <p:cNvPr id="833" name="Google Shape;833;p12"/>
          <p:cNvSpPr/>
          <p:nvPr/>
        </p:nvSpPr>
        <p:spPr>
          <a:xfrm>
            <a:off x="4906400" y="1721236"/>
            <a:ext cx="1626941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Mode: 58 +/- 0.7 nm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4" name="Google Shape;834;p12"/>
          <p:cNvSpPr/>
          <p:nvPr/>
        </p:nvSpPr>
        <p:spPr>
          <a:xfrm>
            <a:off x="3848439" y="669012"/>
            <a:ext cx="908796" cy="3077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900"/>
            </a:pPr>
            <a:r>
              <a:rPr lang="en-US" sz="12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.05E+09</a:t>
            </a:r>
            <a:endParaRPr sz="12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5" name="Google Shape;835;p12"/>
          <p:cNvSpPr/>
          <p:nvPr/>
        </p:nvSpPr>
        <p:spPr>
          <a:xfrm>
            <a:off x="1742877" y="1398426"/>
            <a:ext cx="1982529" cy="338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50"/>
            </a:pPr>
            <a:r>
              <a:rPr lang="en-US" sz="14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24-GFP exosome</a:t>
            </a:r>
            <a:endParaRPr sz="1867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6" name="Google Shape;836;p12"/>
          <p:cNvSpPr/>
          <p:nvPr/>
        </p:nvSpPr>
        <p:spPr>
          <a:xfrm>
            <a:off x="4572254" y="1264402"/>
            <a:ext cx="2191959" cy="5539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50"/>
            </a:pPr>
            <a:r>
              <a:rPr lang="en-US" sz="14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D24-Ecto-tVSVG-GFP exosome</a:t>
            </a:r>
            <a:endParaRPr sz="1867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7" name="Google Shape;837;p12"/>
          <p:cNvSpPr txBox="1"/>
          <p:nvPr/>
        </p:nvSpPr>
        <p:spPr>
          <a:xfrm>
            <a:off x="928224" y="2643875"/>
            <a:ext cx="3268637" cy="3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200"/>
            </a:pPr>
            <a:r>
              <a:rPr lang="en-US" sz="16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   200     400     600     800    1000</a:t>
            </a:r>
            <a:endParaRPr sz="16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38" name="Google Shape;838;p12"/>
          <p:cNvSpPr txBox="1"/>
          <p:nvPr/>
        </p:nvSpPr>
        <p:spPr>
          <a:xfrm>
            <a:off x="2216982" y="5716809"/>
            <a:ext cx="1024417" cy="3281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ize (nm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9" name="Google Shape;839;p12"/>
          <p:cNvSpPr txBox="1"/>
          <p:nvPr/>
        </p:nvSpPr>
        <p:spPr>
          <a:xfrm>
            <a:off x="4179422" y="2659507"/>
            <a:ext cx="3268637" cy="3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200"/>
            </a:pPr>
            <a:r>
              <a:rPr lang="en-US" sz="16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   200     400     600     800    1000</a:t>
            </a:r>
            <a:endParaRPr sz="16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40" name="Google Shape;840;p12"/>
          <p:cNvSpPr txBox="1"/>
          <p:nvPr/>
        </p:nvSpPr>
        <p:spPr>
          <a:xfrm>
            <a:off x="7477514" y="2675138"/>
            <a:ext cx="3268637" cy="3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200"/>
            </a:pPr>
            <a:r>
              <a:rPr lang="en-US" sz="16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   200     400     600     800    1000</a:t>
            </a:r>
            <a:endParaRPr sz="16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41" name="Google Shape;841;p12"/>
          <p:cNvSpPr txBox="1"/>
          <p:nvPr/>
        </p:nvSpPr>
        <p:spPr>
          <a:xfrm>
            <a:off x="4335732" y="5441785"/>
            <a:ext cx="3268637" cy="3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200"/>
            </a:pPr>
            <a:r>
              <a:rPr lang="en-US" sz="16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   200     400     600     800    1000</a:t>
            </a:r>
            <a:endParaRPr sz="16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42" name="Google Shape;842;p12"/>
          <p:cNvSpPr txBox="1"/>
          <p:nvPr/>
        </p:nvSpPr>
        <p:spPr>
          <a:xfrm>
            <a:off x="1022014" y="5457415"/>
            <a:ext cx="3268637" cy="3692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200"/>
            </a:pPr>
            <a:r>
              <a:rPr lang="en-US" sz="16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   200     400     600     800    1000</a:t>
            </a:r>
            <a:endParaRPr sz="160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43" name="Google Shape;843;p12"/>
          <p:cNvSpPr txBox="1"/>
          <p:nvPr/>
        </p:nvSpPr>
        <p:spPr>
          <a:xfrm>
            <a:off x="5374397" y="5720717"/>
            <a:ext cx="1024417" cy="3281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ize (nm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4" name="Google Shape;844;p12"/>
          <p:cNvSpPr txBox="1"/>
          <p:nvPr/>
        </p:nvSpPr>
        <p:spPr>
          <a:xfrm rot="-5400000">
            <a:off x="78604" y="1407404"/>
            <a:ext cx="1425520" cy="5332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centration (particles/mL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5" name="Google Shape;845;p12"/>
          <p:cNvSpPr txBox="1"/>
          <p:nvPr/>
        </p:nvSpPr>
        <p:spPr>
          <a:xfrm>
            <a:off x="1939536" y="2918901"/>
            <a:ext cx="1024417" cy="3281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ize (nm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6" name="Google Shape;846;p12"/>
          <p:cNvSpPr txBox="1"/>
          <p:nvPr/>
        </p:nvSpPr>
        <p:spPr>
          <a:xfrm>
            <a:off x="5190732" y="2899363"/>
            <a:ext cx="1024417" cy="3281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ize (nm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7" name="Google Shape;847;p12"/>
          <p:cNvSpPr txBox="1"/>
          <p:nvPr/>
        </p:nvSpPr>
        <p:spPr>
          <a:xfrm rot="-5400000">
            <a:off x="71229" y="4345992"/>
            <a:ext cx="1488044" cy="5332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centration (particles/mL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8" name="Google Shape;848;p12"/>
          <p:cNvSpPr txBox="1"/>
          <p:nvPr/>
        </p:nvSpPr>
        <p:spPr>
          <a:xfrm rot="-5400000">
            <a:off x="6647432" y="1528543"/>
            <a:ext cx="1425520" cy="5332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centration (particles/mL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9" name="Google Shape;849;p12"/>
          <p:cNvSpPr txBox="1"/>
          <p:nvPr/>
        </p:nvSpPr>
        <p:spPr>
          <a:xfrm rot="-5400000">
            <a:off x="3404051" y="4334266"/>
            <a:ext cx="1425520" cy="5332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centration (particles/mL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0" name="Google Shape;850;p12"/>
          <p:cNvSpPr txBox="1"/>
          <p:nvPr/>
        </p:nvSpPr>
        <p:spPr>
          <a:xfrm rot="-5400000">
            <a:off x="3337616" y="1419127"/>
            <a:ext cx="1425520" cy="5332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ctr"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ncentration (particles/mL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1" name="Google Shape;851;p12"/>
          <p:cNvSpPr txBox="1"/>
          <p:nvPr/>
        </p:nvSpPr>
        <p:spPr>
          <a:xfrm>
            <a:off x="8477101" y="2903271"/>
            <a:ext cx="1024417" cy="3281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000"/>
            </a:pPr>
            <a:r>
              <a:rPr lang="en-US" sz="1333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ize (nm)</a:t>
            </a:r>
            <a:endParaRPr sz="1333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3" name="Google Shape;853;p12"/>
          <p:cNvSpPr txBox="1"/>
          <p:nvPr/>
        </p:nvSpPr>
        <p:spPr>
          <a:xfrm>
            <a:off x="7627095" y="3504338"/>
            <a:ext cx="4434277" cy="24216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 algn="just">
              <a:buClr>
                <a:srgbClr val="000000"/>
              </a:buClr>
              <a:buSzPts val="1400"/>
            </a:pPr>
            <a:r>
              <a:rPr lang="en-US" sz="1867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igure S3</a:t>
            </a:r>
            <a:r>
              <a:rPr lang="en-US" sz="1867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Nanoparticle tracking analysis of isolated exosomes with various genetic modifications (A-D) or non-modification (E). Size and distribution of exosomes </a:t>
            </a:r>
            <a:r>
              <a:rPr lang="en-US" sz="1867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was </a:t>
            </a:r>
            <a:r>
              <a:rPr lang="en-US" sz="1867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graphed using NTA software. One dominant peak with a mode size falls in the </a:t>
            </a:r>
            <a:r>
              <a:rPr lang="en-US" sz="1867" dirty="0" smtClean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ange </a:t>
            </a:r>
            <a:r>
              <a:rPr lang="en-US" sz="1867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of 58 ~ 85 nm. </a:t>
            </a:r>
            <a:endParaRPr sz="1867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4" name="Google Shape;854;p12"/>
          <p:cNvSpPr txBox="1"/>
          <p:nvPr/>
        </p:nvSpPr>
        <p:spPr>
          <a:xfrm>
            <a:off x="192000" y="508801"/>
            <a:ext cx="825600" cy="41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400"/>
            </a:pPr>
            <a:r>
              <a:rPr lang="en-US" sz="1867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867" b="1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5" name="Google Shape;855;p12"/>
          <p:cNvSpPr txBox="1"/>
          <p:nvPr/>
        </p:nvSpPr>
        <p:spPr>
          <a:xfrm>
            <a:off x="174400" y="3313601"/>
            <a:ext cx="825600" cy="41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400"/>
            </a:pPr>
            <a:r>
              <a:rPr lang="en-US" sz="1867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867" b="1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6" name="Google Shape;856;p12"/>
          <p:cNvSpPr txBox="1"/>
          <p:nvPr/>
        </p:nvSpPr>
        <p:spPr>
          <a:xfrm>
            <a:off x="3563200" y="520001"/>
            <a:ext cx="825600" cy="41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400"/>
            </a:pPr>
            <a:r>
              <a:rPr lang="en-US" sz="1867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867" b="1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7" name="Google Shape;857;p12"/>
          <p:cNvSpPr txBox="1"/>
          <p:nvPr/>
        </p:nvSpPr>
        <p:spPr>
          <a:xfrm>
            <a:off x="3545600" y="3324801"/>
            <a:ext cx="825600" cy="41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400"/>
            </a:pPr>
            <a:r>
              <a:rPr lang="en-US" sz="1867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867" b="1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8" name="Google Shape;858;p12"/>
          <p:cNvSpPr txBox="1"/>
          <p:nvPr/>
        </p:nvSpPr>
        <p:spPr>
          <a:xfrm>
            <a:off x="6868800" y="590401"/>
            <a:ext cx="825600" cy="410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60933" rIns="121900" bIns="60933" anchor="t" anchorCtr="0">
            <a:spAutoFit/>
          </a:bodyPr>
          <a:lstStyle/>
          <a:p>
            <a:pPr>
              <a:buClr>
                <a:srgbClr val="000000"/>
              </a:buClr>
              <a:buSzPts val="1400"/>
            </a:pPr>
            <a:r>
              <a:rPr lang="en-US" sz="1867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867" b="1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4</TotalTime>
  <Words>529</Words>
  <Application>Microsoft Office PowerPoint</Application>
  <PresentationFormat>Widescreen</PresentationFormat>
  <Paragraphs>102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O</dc:creator>
  <cp:lastModifiedBy>SCUTechSupport</cp:lastModifiedBy>
  <cp:revision>18</cp:revision>
  <dcterms:created xsi:type="dcterms:W3CDTF">2024-03-12T21:02:17Z</dcterms:created>
  <dcterms:modified xsi:type="dcterms:W3CDTF">2024-05-10T15:41:50Z</dcterms:modified>
</cp:coreProperties>
</file>